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50" d="100"/>
          <a:sy n="150" d="100"/>
        </p:scale>
        <p:origin x="540" y="45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01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356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528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238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820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9613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1121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876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478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024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66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090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Line 5"/>
          <p:cNvSpPr>
            <a:spLocks noChangeShapeType="1"/>
          </p:cNvSpPr>
          <p:nvPr/>
        </p:nvSpPr>
        <p:spPr bwMode="auto">
          <a:xfrm>
            <a:off x="3198813" y="6502400"/>
            <a:ext cx="1460500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bevel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" name="Rectangle 6"/>
          <p:cNvSpPr>
            <a:spLocks noChangeArrowheads="1"/>
          </p:cNvSpPr>
          <p:nvPr/>
        </p:nvSpPr>
        <p:spPr bwMode="auto">
          <a:xfrm>
            <a:off x="3867150" y="658336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0.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" name="Freeform 7"/>
          <p:cNvSpPr>
            <a:spLocks/>
          </p:cNvSpPr>
          <p:nvPr/>
        </p:nvSpPr>
        <p:spPr bwMode="auto">
          <a:xfrm>
            <a:off x="6708775" y="4117975"/>
            <a:ext cx="1116013" cy="1069975"/>
          </a:xfrm>
          <a:custGeom>
            <a:avLst/>
            <a:gdLst>
              <a:gd name="T0" fmla="*/ 0 w 4116"/>
              <a:gd name="T1" fmla="*/ 0 h 2956"/>
              <a:gd name="T2" fmla="*/ 0 w 4116"/>
              <a:gd name="T3" fmla="*/ 1478 h 2956"/>
              <a:gd name="T4" fmla="*/ 0 w 4116"/>
              <a:gd name="T5" fmla="*/ 2956 h 2956"/>
              <a:gd name="T6" fmla="*/ 320 w 4116"/>
              <a:gd name="T7" fmla="*/ 2956 h 2956"/>
              <a:gd name="T8" fmla="*/ 320 w 4116"/>
              <a:gd name="T9" fmla="*/ 2384 h 2956"/>
              <a:gd name="T10" fmla="*/ 4116 w 4116"/>
              <a:gd name="T11" fmla="*/ 2384 h 2956"/>
              <a:gd name="T12" fmla="*/ 4116 w 4116"/>
              <a:gd name="T13" fmla="*/ 1621 h 2956"/>
              <a:gd name="T14" fmla="*/ 559 w 4116"/>
              <a:gd name="T15" fmla="*/ 1621 h 2956"/>
              <a:gd name="T16" fmla="*/ 559 w 4116"/>
              <a:gd name="T17" fmla="*/ 1240 h 2956"/>
              <a:gd name="T18" fmla="*/ 559 w 4116"/>
              <a:gd name="T19" fmla="*/ 1240 h 2956"/>
              <a:gd name="T20" fmla="*/ 559 w 4116"/>
              <a:gd name="T21" fmla="*/ 668 h 2956"/>
              <a:gd name="T22" fmla="*/ 306 w 4116"/>
              <a:gd name="T23" fmla="*/ 668 h 2956"/>
              <a:gd name="T24" fmla="*/ 306 w 4116"/>
              <a:gd name="T25" fmla="*/ 0 h 2956"/>
              <a:gd name="T26" fmla="*/ 0 w 4116"/>
              <a:gd name="T27" fmla="*/ 0 h 29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4116" h="2956">
                <a:moveTo>
                  <a:pt x="0" y="0"/>
                </a:moveTo>
                <a:lnTo>
                  <a:pt x="0" y="1478"/>
                </a:lnTo>
                <a:lnTo>
                  <a:pt x="0" y="2956"/>
                </a:lnTo>
                <a:lnTo>
                  <a:pt x="320" y="2956"/>
                </a:lnTo>
                <a:lnTo>
                  <a:pt x="320" y="2384"/>
                </a:lnTo>
                <a:lnTo>
                  <a:pt x="4116" y="2384"/>
                </a:lnTo>
                <a:lnTo>
                  <a:pt x="4116" y="1621"/>
                </a:lnTo>
                <a:lnTo>
                  <a:pt x="559" y="1621"/>
                </a:lnTo>
                <a:lnTo>
                  <a:pt x="559" y="1240"/>
                </a:lnTo>
                <a:lnTo>
                  <a:pt x="559" y="1240"/>
                </a:lnTo>
                <a:lnTo>
                  <a:pt x="559" y="668"/>
                </a:lnTo>
                <a:lnTo>
                  <a:pt x="306" y="668"/>
                </a:lnTo>
                <a:lnTo>
                  <a:pt x="306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0" name="Freeform 8"/>
          <p:cNvSpPr>
            <a:spLocks/>
          </p:cNvSpPr>
          <p:nvPr/>
        </p:nvSpPr>
        <p:spPr bwMode="auto">
          <a:xfrm>
            <a:off x="6446838" y="3048000"/>
            <a:ext cx="1377950" cy="1009650"/>
          </a:xfrm>
          <a:custGeom>
            <a:avLst/>
            <a:gdLst>
              <a:gd name="T0" fmla="*/ 0 w 5079"/>
              <a:gd name="T1" fmla="*/ 0 h 2788"/>
              <a:gd name="T2" fmla="*/ 0 w 5079"/>
              <a:gd name="T3" fmla="*/ 1394 h 2788"/>
              <a:gd name="T4" fmla="*/ 0 w 5079"/>
              <a:gd name="T5" fmla="*/ 2788 h 2788"/>
              <a:gd name="T6" fmla="*/ 359 w 5079"/>
              <a:gd name="T7" fmla="*/ 2788 h 2788"/>
              <a:gd name="T8" fmla="*/ 359 w 5079"/>
              <a:gd name="T9" fmla="*/ 1144 h 2788"/>
              <a:gd name="T10" fmla="*/ 359 w 5079"/>
              <a:gd name="T11" fmla="*/ 1144 h 2788"/>
              <a:gd name="T12" fmla="*/ 359 w 5079"/>
              <a:gd name="T13" fmla="*/ 763 h 2788"/>
              <a:gd name="T14" fmla="*/ 5079 w 5079"/>
              <a:gd name="T15" fmla="*/ 763 h 2788"/>
              <a:gd name="T16" fmla="*/ 5079 w 5079"/>
              <a:gd name="T17" fmla="*/ 0 h 2788"/>
              <a:gd name="T18" fmla="*/ 0 w 5079"/>
              <a:gd name="T19" fmla="*/ 0 h 278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5079" h="2788">
                <a:moveTo>
                  <a:pt x="0" y="0"/>
                </a:moveTo>
                <a:lnTo>
                  <a:pt x="0" y="1394"/>
                </a:lnTo>
                <a:lnTo>
                  <a:pt x="0" y="2788"/>
                </a:lnTo>
                <a:lnTo>
                  <a:pt x="359" y="2788"/>
                </a:lnTo>
                <a:lnTo>
                  <a:pt x="359" y="1144"/>
                </a:lnTo>
                <a:lnTo>
                  <a:pt x="359" y="1144"/>
                </a:lnTo>
                <a:lnTo>
                  <a:pt x="359" y="763"/>
                </a:lnTo>
                <a:lnTo>
                  <a:pt x="5079" y="763"/>
                </a:lnTo>
                <a:lnTo>
                  <a:pt x="5079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1" name="Freeform 9"/>
          <p:cNvSpPr>
            <a:spLocks/>
          </p:cNvSpPr>
          <p:nvPr/>
        </p:nvSpPr>
        <p:spPr bwMode="auto">
          <a:xfrm>
            <a:off x="6545263" y="3324225"/>
            <a:ext cx="1279525" cy="276225"/>
          </a:xfrm>
          <a:custGeom>
            <a:avLst/>
            <a:gdLst>
              <a:gd name="T0" fmla="*/ 0 w 4720"/>
              <a:gd name="T1" fmla="*/ 0 h 762"/>
              <a:gd name="T2" fmla="*/ 0 w 4720"/>
              <a:gd name="T3" fmla="*/ 381 h 762"/>
              <a:gd name="T4" fmla="*/ 0 w 4720"/>
              <a:gd name="T5" fmla="*/ 762 h 762"/>
              <a:gd name="T6" fmla="*/ 4720 w 4720"/>
              <a:gd name="T7" fmla="*/ 762 h 762"/>
              <a:gd name="T8" fmla="*/ 4720 w 4720"/>
              <a:gd name="T9" fmla="*/ 0 h 762"/>
              <a:gd name="T10" fmla="*/ 0 w 4720"/>
              <a:gd name="T11" fmla="*/ 0 h 7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720" h="762">
                <a:moveTo>
                  <a:pt x="0" y="0"/>
                </a:moveTo>
                <a:lnTo>
                  <a:pt x="0" y="381"/>
                </a:lnTo>
                <a:lnTo>
                  <a:pt x="0" y="762"/>
                </a:lnTo>
                <a:lnTo>
                  <a:pt x="4720" y="762"/>
                </a:lnTo>
                <a:lnTo>
                  <a:pt x="4720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2" name="Freeform 10"/>
          <p:cNvSpPr>
            <a:spLocks/>
          </p:cNvSpPr>
          <p:nvPr/>
        </p:nvSpPr>
        <p:spPr bwMode="auto">
          <a:xfrm>
            <a:off x="2811463" y="1114425"/>
            <a:ext cx="5013325" cy="276225"/>
          </a:xfrm>
          <a:custGeom>
            <a:avLst/>
            <a:gdLst>
              <a:gd name="T0" fmla="*/ 0 w 18480"/>
              <a:gd name="T1" fmla="*/ 0 h 762"/>
              <a:gd name="T2" fmla="*/ 0 w 18480"/>
              <a:gd name="T3" fmla="*/ 381 h 762"/>
              <a:gd name="T4" fmla="*/ 0 w 18480"/>
              <a:gd name="T5" fmla="*/ 762 h 762"/>
              <a:gd name="T6" fmla="*/ 18480 w 18480"/>
              <a:gd name="T7" fmla="*/ 762 h 762"/>
              <a:gd name="T8" fmla="*/ 18480 w 18480"/>
              <a:gd name="T9" fmla="*/ 0 h 762"/>
              <a:gd name="T10" fmla="*/ 0 w 18480"/>
              <a:gd name="T11" fmla="*/ 0 h 7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8480" h="762">
                <a:moveTo>
                  <a:pt x="0" y="0"/>
                </a:moveTo>
                <a:lnTo>
                  <a:pt x="0" y="381"/>
                </a:lnTo>
                <a:lnTo>
                  <a:pt x="0" y="762"/>
                </a:lnTo>
                <a:lnTo>
                  <a:pt x="18480" y="762"/>
                </a:lnTo>
                <a:lnTo>
                  <a:pt x="18480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3" name="Freeform 11"/>
          <p:cNvSpPr>
            <a:spLocks/>
          </p:cNvSpPr>
          <p:nvPr/>
        </p:nvSpPr>
        <p:spPr bwMode="auto">
          <a:xfrm>
            <a:off x="6545263" y="3462338"/>
            <a:ext cx="1279525" cy="1190625"/>
          </a:xfrm>
          <a:custGeom>
            <a:avLst/>
            <a:gdLst>
              <a:gd name="T0" fmla="*/ 0 w 4720"/>
              <a:gd name="T1" fmla="*/ 0 h 3289"/>
              <a:gd name="T2" fmla="*/ 0 w 4720"/>
              <a:gd name="T3" fmla="*/ 1644 h 3289"/>
              <a:gd name="T4" fmla="*/ 0 w 4720"/>
              <a:gd name="T5" fmla="*/ 3289 h 3289"/>
              <a:gd name="T6" fmla="*/ 604 w 4720"/>
              <a:gd name="T7" fmla="*/ 3289 h 3289"/>
              <a:gd name="T8" fmla="*/ 604 w 4720"/>
              <a:gd name="T9" fmla="*/ 1811 h 3289"/>
              <a:gd name="T10" fmla="*/ 910 w 4720"/>
              <a:gd name="T11" fmla="*/ 1811 h 3289"/>
              <a:gd name="T12" fmla="*/ 910 w 4720"/>
              <a:gd name="T13" fmla="*/ 1144 h 3289"/>
              <a:gd name="T14" fmla="*/ 4720 w 4720"/>
              <a:gd name="T15" fmla="*/ 1144 h 3289"/>
              <a:gd name="T16" fmla="*/ 4720 w 4720"/>
              <a:gd name="T17" fmla="*/ 381 h 3289"/>
              <a:gd name="T18" fmla="*/ 0 w 4720"/>
              <a:gd name="T19" fmla="*/ 381 h 3289"/>
              <a:gd name="T20" fmla="*/ 0 w 4720"/>
              <a:gd name="T21" fmla="*/ 0 h 32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</a:cxnLst>
            <a:rect l="0" t="0" r="r" b="b"/>
            <a:pathLst>
              <a:path w="4720" h="3289">
                <a:moveTo>
                  <a:pt x="0" y="0"/>
                </a:moveTo>
                <a:lnTo>
                  <a:pt x="0" y="1644"/>
                </a:lnTo>
                <a:lnTo>
                  <a:pt x="0" y="3289"/>
                </a:lnTo>
                <a:lnTo>
                  <a:pt x="604" y="3289"/>
                </a:lnTo>
                <a:lnTo>
                  <a:pt x="604" y="1811"/>
                </a:lnTo>
                <a:lnTo>
                  <a:pt x="910" y="1811"/>
                </a:lnTo>
                <a:lnTo>
                  <a:pt x="910" y="1144"/>
                </a:lnTo>
                <a:lnTo>
                  <a:pt x="4720" y="1144"/>
                </a:lnTo>
                <a:lnTo>
                  <a:pt x="4720" y="381"/>
                </a:lnTo>
                <a:lnTo>
                  <a:pt x="0" y="381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4" name="Freeform 12"/>
          <p:cNvSpPr>
            <a:spLocks/>
          </p:cNvSpPr>
          <p:nvPr/>
        </p:nvSpPr>
        <p:spPr bwMode="auto">
          <a:xfrm>
            <a:off x="6859588" y="4152900"/>
            <a:ext cx="965200" cy="414338"/>
          </a:xfrm>
          <a:custGeom>
            <a:avLst/>
            <a:gdLst>
              <a:gd name="T0" fmla="*/ 0 w 3557"/>
              <a:gd name="T1" fmla="*/ 0 h 1144"/>
              <a:gd name="T2" fmla="*/ 0 w 3557"/>
              <a:gd name="T3" fmla="*/ 572 h 1144"/>
              <a:gd name="T4" fmla="*/ 0 w 3557"/>
              <a:gd name="T5" fmla="*/ 1144 h 1144"/>
              <a:gd name="T6" fmla="*/ 0 w 3557"/>
              <a:gd name="T7" fmla="*/ 1144 h 1144"/>
              <a:gd name="T8" fmla="*/ 0 w 3557"/>
              <a:gd name="T9" fmla="*/ 762 h 1144"/>
              <a:gd name="T10" fmla="*/ 3557 w 3557"/>
              <a:gd name="T11" fmla="*/ 762 h 1144"/>
              <a:gd name="T12" fmla="*/ 3557 w 3557"/>
              <a:gd name="T13" fmla="*/ 0 h 1144"/>
              <a:gd name="T14" fmla="*/ 0 w 3557"/>
              <a:gd name="T15" fmla="*/ 0 h 1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557" h="1144">
                <a:moveTo>
                  <a:pt x="0" y="0"/>
                </a:moveTo>
                <a:lnTo>
                  <a:pt x="0" y="572"/>
                </a:lnTo>
                <a:lnTo>
                  <a:pt x="0" y="1144"/>
                </a:lnTo>
                <a:lnTo>
                  <a:pt x="0" y="1144"/>
                </a:lnTo>
                <a:lnTo>
                  <a:pt x="0" y="762"/>
                </a:lnTo>
                <a:lnTo>
                  <a:pt x="3557" y="762"/>
                </a:lnTo>
                <a:lnTo>
                  <a:pt x="3557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5" name="Freeform 13"/>
          <p:cNvSpPr>
            <a:spLocks/>
          </p:cNvSpPr>
          <p:nvPr/>
        </p:nvSpPr>
        <p:spPr bwMode="auto">
          <a:xfrm>
            <a:off x="419100" y="735013"/>
            <a:ext cx="7405688" cy="1216025"/>
          </a:xfrm>
          <a:custGeom>
            <a:avLst/>
            <a:gdLst>
              <a:gd name="T0" fmla="*/ 0 w 27295"/>
              <a:gd name="T1" fmla="*/ 0 h 3357"/>
              <a:gd name="T2" fmla="*/ 0 w 27295"/>
              <a:gd name="T3" fmla="*/ 1678 h 3357"/>
              <a:gd name="T4" fmla="*/ 0 w 27295"/>
              <a:gd name="T5" fmla="*/ 3357 h 3357"/>
              <a:gd name="T6" fmla="*/ 2179 w 27295"/>
              <a:gd name="T7" fmla="*/ 3357 h 3357"/>
              <a:gd name="T8" fmla="*/ 2179 w 27295"/>
              <a:gd name="T9" fmla="*/ 2574 h 3357"/>
              <a:gd name="T10" fmla="*/ 27295 w 27295"/>
              <a:gd name="T11" fmla="*/ 2574 h 3357"/>
              <a:gd name="T12" fmla="*/ 27295 w 27295"/>
              <a:gd name="T13" fmla="*/ 1811 h 3357"/>
              <a:gd name="T14" fmla="*/ 8815 w 27295"/>
              <a:gd name="T15" fmla="*/ 1811 h 3357"/>
              <a:gd name="T16" fmla="*/ 8815 w 27295"/>
              <a:gd name="T17" fmla="*/ 1430 h 3357"/>
              <a:gd name="T18" fmla="*/ 6381 w 27295"/>
              <a:gd name="T19" fmla="*/ 1430 h 3357"/>
              <a:gd name="T20" fmla="*/ 6381 w 27295"/>
              <a:gd name="T21" fmla="*/ 858 h 3357"/>
              <a:gd name="T22" fmla="*/ 2259 w 27295"/>
              <a:gd name="T23" fmla="*/ 858 h 3357"/>
              <a:gd name="T24" fmla="*/ 2259 w 27295"/>
              <a:gd name="T25" fmla="*/ 0 h 3357"/>
              <a:gd name="T26" fmla="*/ 0 w 27295"/>
              <a:gd name="T27" fmla="*/ 0 h 33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7295" h="3357">
                <a:moveTo>
                  <a:pt x="0" y="0"/>
                </a:moveTo>
                <a:lnTo>
                  <a:pt x="0" y="1678"/>
                </a:lnTo>
                <a:lnTo>
                  <a:pt x="0" y="3357"/>
                </a:lnTo>
                <a:lnTo>
                  <a:pt x="2179" y="3357"/>
                </a:lnTo>
                <a:lnTo>
                  <a:pt x="2179" y="2574"/>
                </a:lnTo>
                <a:lnTo>
                  <a:pt x="27295" y="2574"/>
                </a:lnTo>
                <a:lnTo>
                  <a:pt x="27295" y="1811"/>
                </a:lnTo>
                <a:lnTo>
                  <a:pt x="8815" y="1811"/>
                </a:lnTo>
                <a:lnTo>
                  <a:pt x="8815" y="1430"/>
                </a:lnTo>
                <a:lnTo>
                  <a:pt x="6381" y="1430"/>
                </a:lnTo>
                <a:lnTo>
                  <a:pt x="6381" y="858"/>
                </a:lnTo>
                <a:lnTo>
                  <a:pt x="2259" y="858"/>
                </a:lnTo>
                <a:lnTo>
                  <a:pt x="2259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6" name="Freeform 14"/>
          <p:cNvSpPr>
            <a:spLocks/>
          </p:cNvSpPr>
          <p:nvPr/>
        </p:nvSpPr>
        <p:spPr bwMode="auto">
          <a:xfrm>
            <a:off x="6807200" y="5256213"/>
            <a:ext cx="1017588" cy="276225"/>
          </a:xfrm>
          <a:custGeom>
            <a:avLst/>
            <a:gdLst>
              <a:gd name="T0" fmla="*/ 0 w 3755"/>
              <a:gd name="T1" fmla="*/ 0 h 762"/>
              <a:gd name="T2" fmla="*/ 0 w 3755"/>
              <a:gd name="T3" fmla="*/ 381 h 762"/>
              <a:gd name="T4" fmla="*/ 0 w 3755"/>
              <a:gd name="T5" fmla="*/ 762 h 762"/>
              <a:gd name="T6" fmla="*/ 3755 w 3755"/>
              <a:gd name="T7" fmla="*/ 762 h 762"/>
              <a:gd name="T8" fmla="*/ 3755 w 3755"/>
              <a:gd name="T9" fmla="*/ 0 h 762"/>
              <a:gd name="T10" fmla="*/ 0 w 3755"/>
              <a:gd name="T11" fmla="*/ 0 h 7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755" h="762">
                <a:moveTo>
                  <a:pt x="0" y="0"/>
                </a:moveTo>
                <a:lnTo>
                  <a:pt x="0" y="381"/>
                </a:lnTo>
                <a:lnTo>
                  <a:pt x="0" y="762"/>
                </a:lnTo>
                <a:lnTo>
                  <a:pt x="3755" y="762"/>
                </a:lnTo>
                <a:lnTo>
                  <a:pt x="3755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7" name="Freeform 15"/>
          <p:cNvSpPr>
            <a:spLocks/>
          </p:cNvSpPr>
          <p:nvPr/>
        </p:nvSpPr>
        <p:spPr bwMode="auto">
          <a:xfrm>
            <a:off x="109538" y="1343025"/>
            <a:ext cx="7715250" cy="4811713"/>
          </a:xfrm>
          <a:custGeom>
            <a:avLst/>
            <a:gdLst>
              <a:gd name="T0" fmla="*/ 0 w 28436"/>
              <a:gd name="T1" fmla="*/ 0 h 13290"/>
              <a:gd name="T2" fmla="*/ 0 w 28436"/>
              <a:gd name="T3" fmla="*/ 6645 h 13290"/>
              <a:gd name="T4" fmla="*/ 0 w 28436"/>
              <a:gd name="T5" fmla="*/ 13290 h 13290"/>
              <a:gd name="T6" fmla="*/ 5793 w 28436"/>
              <a:gd name="T7" fmla="*/ 13290 h 13290"/>
              <a:gd name="T8" fmla="*/ 5793 w 28436"/>
              <a:gd name="T9" fmla="*/ 12718 h 13290"/>
              <a:gd name="T10" fmla="*/ 12190 w 28436"/>
              <a:gd name="T11" fmla="*/ 12718 h 13290"/>
              <a:gd name="T12" fmla="*/ 12190 w 28436"/>
              <a:gd name="T13" fmla="*/ 12337 h 13290"/>
              <a:gd name="T14" fmla="*/ 28436 w 28436"/>
              <a:gd name="T15" fmla="*/ 12337 h 13290"/>
              <a:gd name="T16" fmla="*/ 28436 w 28436"/>
              <a:gd name="T17" fmla="*/ 11574 h 13290"/>
              <a:gd name="T18" fmla="*/ 24681 w 28436"/>
              <a:gd name="T19" fmla="*/ 11574 h 13290"/>
              <a:gd name="T20" fmla="*/ 24681 w 28436"/>
              <a:gd name="T21" fmla="*/ 11193 h 13290"/>
              <a:gd name="T22" fmla="*/ 24640 w 28436"/>
              <a:gd name="T23" fmla="*/ 11193 h 13290"/>
              <a:gd name="T24" fmla="*/ 24640 w 28436"/>
              <a:gd name="T25" fmla="*/ 10621 h 13290"/>
              <a:gd name="T26" fmla="*/ 24320 w 28436"/>
              <a:gd name="T27" fmla="*/ 10621 h 13290"/>
              <a:gd name="T28" fmla="*/ 24320 w 28436"/>
              <a:gd name="T29" fmla="*/ 9143 h 13290"/>
              <a:gd name="T30" fmla="*/ 23716 w 28436"/>
              <a:gd name="T31" fmla="*/ 9143 h 13290"/>
              <a:gd name="T32" fmla="*/ 23716 w 28436"/>
              <a:gd name="T33" fmla="*/ 7498 h 13290"/>
              <a:gd name="T34" fmla="*/ 23357 w 28436"/>
              <a:gd name="T35" fmla="*/ 7498 h 13290"/>
              <a:gd name="T36" fmla="*/ 23357 w 28436"/>
              <a:gd name="T37" fmla="*/ 6104 h 13290"/>
              <a:gd name="T38" fmla="*/ 21483 w 28436"/>
              <a:gd name="T39" fmla="*/ 6104 h 13290"/>
              <a:gd name="T40" fmla="*/ 21483 w 28436"/>
              <a:gd name="T41" fmla="*/ 5026 h 13290"/>
              <a:gd name="T42" fmla="*/ 12293 w 28436"/>
              <a:gd name="T43" fmla="*/ 5026 h 13290"/>
              <a:gd name="T44" fmla="*/ 12293 w 28436"/>
              <a:gd name="T45" fmla="*/ 4105 h 13290"/>
              <a:gd name="T46" fmla="*/ 8466 w 28436"/>
              <a:gd name="T47" fmla="*/ 4105 h 13290"/>
              <a:gd name="T48" fmla="*/ 8466 w 28436"/>
              <a:gd name="T49" fmla="*/ 3263 h 13290"/>
              <a:gd name="T50" fmla="*/ 6273 w 28436"/>
              <a:gd name="T51" fmla="*/ 3263 h 13290"/>
              <a:gd name="T52" fmla="*/ 6273 w 28436"/>
              <a:gd name="T53" fmla="*/ 2461 h 13290"/>
              <a:gd name="T54" fmla="*/ 3320 w 28436"/>
              <a:gd name="T55" fmla="*/ 2461 h 13290"/>
              <a:gd name="T56" fmla="*/ 3320 w 28436"/>
              <a:gd name="T57" fmla="*/ 1679 h 13290"/>
              <a:gd name="T58" fmla="*/ 1141 w 28436"/>
              <a:gd name="T59" fmla="*/ 1679 h 13290"/>
              <a:gd name="T60" fmla="*/ 1141 w 28436"/>
              <a:gd name="T61" fmla="*/ 0 h 13290"/>
              <a:gd name="T62" fmla="*/ 0 w 28436"/>
              <a:gd name="T63" fmla="*/ 0 h 132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  <a:cxn ang="0">
                <a:pos x="T60" y="T61"/>
              </a:cxn>
              <a:cxn ang="0">
                <a:pos x="T62" y="T63"/>
              </a:cxn>
            </a:cxnLst>
            <a:rect l="0" t="0" r="r" b="b"/>
            <a:pathLst>
              <a:path w="28436" h="13290">
                <a:moveTo>
                  <a:pt x="0" y="0"/>
                </a:moveTo>
                <a:lnTo>
                  <a:pt x="0" y="6645"/>
                </a:lnTo>
                <a:lnTo>
                  <a:pt x="0" y="13290"/>
                </a:lnTo>
                <a:lnTo>
                  <a:pt x="5793" y="13290"/>
                </a:lnTo>
                <a:lnTo>
                  <a:pt x="5793" y="12718"/>
                </a:lnTo>
                <a:lnTo>
                  <a:pt x="12190" y="12718"/>
                </a:lnTo>
                <a:lnTo>
                  <a:pt x="12190" y="12337"/>
                </a:lnTo>
                <a:lnTo>
                  <a:pt x="28436" y="12337"/>
                </a:lnTo>
                <a:lnTo>
                  <a:pt x="28436" y="11574"/>
                </a:lnTo>
                <a:lnTo>
                  <a:pt x="24681" y="11574"/>
                </a:lnTo>
                <a:lnTo>
                  <a:pt x="24681" y="11193"/>
                </a:lnTo>
                <a:lnTo>
                  <a:pt x="24640" y="11193"/>
                </a:lnTo>
                <a:lnTo>
                  <a:pt x="24640" y="10621"/>
                </a:lnTo>
                <a:lnTo>
                  <a:pt x="24320" y="10621"/>
                </a:lnTo>
                <a:lnTo>
                  <a:pt x="24320" y="9143"/>
                </a:lnTo>
                <a:lnTo>
                  <a:pt x="23716" y="9143"/>
                </a:lnTo>
                <a:lnTo>
                  <a:pt x="23716" y="7498"/>
                </a:lnTo>
                <a:lnTo>
                  <a:pt x="23357" y="7498"/>
                </a:lnTo>
                <a:lnTo>
                  <a:pt x="23357" y="6104"/>
                </a:lnTo>
                <a:lnTo>
                  <a:pt x="21483" y="6104"/>
                </a:lnTo>
                <a:lnTo>
                  <a:pt x="21483" y="5026"/>
                </a:lnTo>
                <a:lnTo>
                  <a:pt x="12293" y="5026"/>
                </a:lnTo>
                <a:lnTo>
                  <a:pt x="12293" y="4105"/>
                </a:lnTo>
                <a:lnTo>
                  <a:pt x="8466" y="4105"/>
                </a:lnTo>
                <a:lnTo>
                  <a:pt x="8466" y="3263"/>
                </a:lnTo>
                <a:lnTo>
                  <a:pt x="6273" y="3263"/>
                </a:lnTo>
                <a:lnTo>
                  <a:pt x="6273" y="2461"/>
                </a:lnTo>
                <a:lnTo>
                  <a:pt x="3320" y="2461"/>
                </a:lnTo>
                <a:lnTo>
                  <a:pt x="3320" y="1679"/>
                </a:lnTo>
                <a:lnTo>
                  <a:pt x="1141" y="1679"/>
                </a:lnTo>
                <a:lnTo>
                  <a:pt x="1141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8" name="Freeform 16"/>
          <p:cNvSpPr>
            <a:spLocks/>
          </p:cNvSpPr>
          <p:nvPr/>
        </p:nvSpPr>
        <p:spPr bwMode="auto">
          <a:xfrm>
            <a:off x="1462088" y="287338"/>
            <a:ext cx="6362700" cy="274638"/>
          </a:xfrm>
          <a:custGeom>
            <a:avLst/>
            <a:gdLst>
              <a:gd name="T0" fmla="*/ 0 w 23452"/>
              <a:gd name="T1" fmla="*/ 0 h 762"/>
              <a:gd name="T2" fmla="*/ 0 w 23452"/>
              <a:gd name="T3" fmla="*/ 381 h 762"/>
              <a:gd name="T4" fmla="*/ 0 w 23452"/>
              <a:gd name="T5" fmla="*/ 762 h 762"/>
              <a:gd name="T6" fmla="*/ 23452 w 23452"/>
              <a:gd name="T7" fmla="*/ 762 h 762"/>
              <a:gd name="T8" fmla="*/ 23452 w 23452"/>
              <a:gd name="T9" fmla="*/ 0 h 762"/>
              <a:gd name="T10" fmla="*/ 0 w 23452"/>
              <a:gd name="T11" fmla="*/ 0 h 7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3452" h="762">
                <a:moveTo>
                  <a:pt x="0" y="0"/>
                </a:moveTo>
                <a:lnTo>
                  <a:pt x="0" y="381"/>
                </a:lnTo>
                <a:lnTo>
                  <a:pt x="0" y="762"/>
                </a:lnTo>
                <a:lnTo>
                  <a:pt x="23452" y="762"/>
                </a:lnTo>
                <a:lnTo>
                  <a:pt x="23452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9" name="Freeform 17"/>
          <p:cNvSpPr>
            <a:spLocks/>
          </p:cNvSpPr>
          <p:nvPr/>
        </p:nvSpPr>
        <p:spPr bwMode="auto">
          <a:xfrm>
            <a:off x="1681163" y="5946775"/>
            <a:ext cx="6143625" cy="414338"/>
          </a:xfrm>
          <a:custGeom>
            <a:avLst/>
            <a:gdLst>
              <a:gd name="T0" fmla="*/ 0 w 22643"/>
              <a:gd name="T1" fmla="*/ 0 h 1145"/>
              <a:gd name="T2" fmla="*/ 0 w 22643"/>
              <a:gd name="T3" fmla="*/ 572 h 1145"/>
              <a:gd name="T4" fmla="*/ 0 w 22643"/>
              <a:gd name="T5" fmla="*/ 1145 h 1145"/>
              <a:gd name="T6" fmla="*/ 22643 w 22643"/>
              <a:gd name="T7" fmla="*/ 1145 h 1145"/>
              <a:gd name="T8" fmla="*/ 22643 w 22643"/>
              <a:gd name="T9" fmla="*/ 382 h 1145"/>
              <a:gd name="T10" fmla="*/ 6397 w 22643"/>
              <a:gd name="T11" fmla="*/ 382 h 1145"/>
              <a:gd name="T12" fmla="*/ 6397 w 22643"/>
              <a:gd name="T13" fmla="*/ 0 h 1145"/>
              <a:gd name="T14" fmla="*/ 0 w 22643"/>
              <a:gd name="T15" fmla="*/ 0 h 11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2643" h="1145">
                <a:moveTo>
                  <a:pt x="0" y="0"/>
                </a:moveTo>
                <a:lnTo>
                  <a:pt x="0" y="572"/>
                </a:lnTo>
                <a:lnTo>
                  <a:pt x="0" y="1145"/>
                </a:lnTo>
                <a:lnTo>
                  <a:pt x="22643" y="1145"/>
                </a:lnTo>
                <a:lnTo>
                  <a:pt x="22643" y="382"/>
                </a:lnTo>
                <a:lnTo>
                  <a:pt x="6397" y="382"/>
                </a:lnTo>
                <a:lnTo>
                  <a:pt x="6397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0" name="Freeform 18"/>
          <p:cNvSpPr>
            <a:spLocks/>
          </p:cNvSpPr>
          <p:nvPr/>
        </p:nvSpPr>
        <p:spPr bwMode="auto">
          <a:xfrm>
            <a:off x="3417888" y="5808663"/>
            <a:ext cx="4406900" cy="276225"/>
          </a:xfrm>
          <a:custGeom>
            <a:avLst/>
            <a:gdLst>
              <a:gd name="T0" fmla="*/ 0 w 16246"/>
              <a:gd name="T1" fmla="*/ 0 h 763"/>
              <a:gd name="T2" fmla="*/ 0 w 16246"/>
              <a:gd name="T3" fmla="*/ 381 h 763"/>
              <a:gd name="T4" fmla="*/ 0 w 16246"/>
              <a:gd name="T5" fmla="*/ 763 h 763"/>
              <a:gd name="T6" fmla="*/ 16246 w 16246"/>
              <a:gd name="T7" fmla="*/ 763 h 763"/>
              <a:gd name="T8" fmla="*/ 16246 w 16246"/>
              <a:gd name="T9" fmla="*/ 0 h 763"/>
              <a:gd name="T10" fmla="*/ 0 w 16246"/>
              <a:gd name="T11" fmla="*/ 0 h 7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6246" h="763">
                <a:moveTo>
                  <a:pt x="0" y="0"/>
                </a:moveTo>
                <a:lnTo>
                  <a:pt x="0" y="381"/>
                </a:lnTo>
                <a:lnTo>
                  <a:pt x="0" y="763"/>
                </a:lnTo>
                <a:lnTo>
                  <a:pt x="16246" y="763"/>
                </a:lnTo>
                <a:lnTo>
                  <a:pt x="16246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1" name="Freeform 19"/>
          <p:cNvSpPr>
            <a:spLocks/>
          </p:cNvSpPr>
          <p:nvPr/>
        </p:nvSpPr>
        <p:spPr bwMode="auto">
          <a:xfrm>
            <a:off x="6859588" y="4429125"/>
            <a:ext cx="965200" cy="274638"/>
          </a:xfrm>
          <a:custGeom>
            <a:avLst/>
            <a:gdLst>
              <a:gd name="T0" fmla="*/ 0 w 3557"/>
              <a:gd name="T1" fmla="*/ 0 h 763"/>
              <a:gd name="T2" fmla="*/ 0 w 3557"/>
              <a:gd name="T3" fmla="*/ 382 h 763"/>
              <a:gd name="T4" fmla="*/ 0 w 3557"/>
              <a:gd name="T5" fmla="*/ 763 h 763"/>
              <a:gd name="T6" fmla="*/ 3557 w 3557"/>
              <a:gd name="T7" fmla="*/ 763 h 763"/>
              <a:gd name="T8" fmla="*/ 3557 w 3557"/>
              <a:gd name="T9" fmla="*/ 0 h 763"/>
              <a:gd name="T10" fmla="*/ 0 w 3557"/>
              <a:gd name="T11" fmla="*/ 0 h 7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557" h="763">
                <a:moveTo>
                  <a:pt x="0" y="0"/>
                </a:moveTo>
                <a:lnTo>
                  <a:pt x="0" y="382"/>
                </a:lnTo>
                <a:lnTo>
                  <a:pt x="0" y="763"/>
                </a:lnTo>
                <a:lnTo>
                  <a:pt x="3557" y="763"/>
                </a:lnTo>
                <a:lnTo>
                  <a:pt x="3557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2" name="Freeform 20"/>
          <p:cNvSpPr>
            <a:spLocks/>
          </p:cNvSpPr>
          <p:nvPr/>
        </p:nvSpPr>
        <p:spPr bwMode="auto">
          <a:xfrm>
            <a:off x="6791325" y="3876675"/>
            <a:ext cx="1033463" cy="482600"/>
          </a:xfrm>
          <a:custGeom>
            <a:avLst/>
            <a:gdLst>
              <a:gd name="T0" fmla="*/ 0 w 3810"/>
              <a:gd name="T1" fmla="*/ 0 h 1335"/>
              <a:gd name="T2" fmla="*/ 0 w 3810"/>
              <a:gd name="T3" fmla="*/ 667 h 1335"/>
              <a:gd name="T4" fmla="*/ 0 w 3810"/>
              <a:gd name="T5" fmla="*/ 1335 h 1335"/>
              <a:gd name="T6" fmla="*/ 253 w 3810"/>
              <a:gd name="T7" fmla="*/ 1335 h 1335"/>
              <a:gd name="T8" fmla="*/ 253 w 3810"/>
              <a:gd name="T9" fmla="*/ 763 h 1335"/>
              <a:gd name="T10" fmla="*/ 3810 w 3810"/>
              <a:gd name="T11" fmla="*/ 763 h 1335"/>
              <a:gd name="T12" fmla="*/ 3810 w 3810"/>
              <a:gd name="T13" fmla="*/ 0 h 1335"/>
              <a:gd name="T14" fmla="*/ 0 w 3810"/>
              <a:gd name="T15" fmla="*/ 0 h 13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810" h="1335">
                <a:moveTo>
                  <a:pt x="0" y="0"/>
                </a:moveTo>
                <a:lnTo>
                  <a:pt x="0" y="667"/>
                </a:lnTo>
                <a:lnTo>
                  <a:pt x="0" y="1335"/>
                </a:lnTo>
                <a:lnTo>
                  <a:pt x="253" y="1335"/>
                </a:lnTo>
                <a:lnTo>
                  <a:pt x="253" y="763"/>
                </a:lnTo>
                <a:lnTo>
                  <a:pt x="3810" y="763"/>
                </a:lnTo>
                <a:lnTo>
                  <a:pt x="3810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3" name="Freeform 21"/>
          <p:cNvSpPr>
            <a:spLocks/>
          </p:cNvSpPr>
          <p:nvPr/>
        </p:nvSpPr>
        <p:spPr bwMode="auto">
          <a:xfrm>
            <a:off x="2406650" y="2219325"/>
            <a:ext cx="5418138" cy="609600"/>
          </a:xfrm>
          <a:custGeom>
            <a:avLst/>
            <a:gdLst>
              <a:gd name="T0" fmla="*/ 0 w 19970"/>
              <a:gd name="T1" fmla="*/ 0 h 1683"/>
              <a:gd name="T2" fmla="*/ 0 w 19970"/>
              <a:gd name="T3" fmla="*/ 841 h 1683"/>
              <a:gd name="T4" fmla="*/ 0 w 19970"/>
              <a:gd name="T5" fmla="*/ 1683 h 1683"/>
              <a:gd name="T6" fmla="*/ 3827 w 19970"/>
              <a:gd name="T7" fmla="*/ 1683 h 1683"/>
              <a:gd name="T8" fmla="*/ 3827 w 19970"/>
              <a:gd name="T9" fmla="*/ 762 h 1683"/>
              <a:gd name="T10" fmla="*/ 19970 w 19970"/>
              <a:gd name="T11" fmla="*/ 762 h 1683"/>
              <a:gd name="T12" fmla="*/ 19970 w 19970"/>
              <a:gd name="T13" fmla="*/ 0 h 1683"/>
              <a:gd name="T14" fmla="*/ 0 w 19970"/>
              <a:gd name="T15" fmla="*/ 0 h 16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9970" h="1683">
                <a:moveTo>
                  <a:pt x="0" y="0"/>
                </a:moveTo>
                <a:lnTo>
                  <a:pt x="0" y="841"/>
                </a:lnTo>
                <a:lnTo>
                  <a:pt x="0" y="1683"/>
                </a:lnTo>
                <a:lnTo>
                  <a:pt x="3827" y="1683"/>
                </a:lnTo>
                <a:lnTo>
                  <a:pt x="3827" y="762"/>
                </a:lnTo>
                <a:lnTo>
                  <a:pt x="19970" y="762"/>
                </a:lnTo>
                <a:lnTo>
                  <a:pt x="19970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4" name="Freeform 22"/>
          <p:cNvSpPr>
            <a:spLocks/>
          </p:cNvSpPr>
          <p:nvPr/>
        </p:nvSpPr>
        <p:spPr bwMode="auto">
          <a:xfrm>
            <a:off x="3444875" y="2495550"/>
            <a:ext cx="4379913" cy="666750"/>
          </a:xfrm>
          <a:custGeom>
            <a:avLst/>
            <a:gdLst>
              <a:gd name="T0" fmla="*/ 0 w 16143"/>
              <a:gd name="T1" fmla="*/ 0 h 1842"/>
              <a:gd name="T2" fmla="*/ 0 w 16143"/>
              <a:gd name="T3" fmla="*/ 921 h 1842"/>
              <a:gd name="T4" fmla="*/ 0 w 16143"/>
              <a:gd name="T5" fmla="*/ 1842 h 1842"/>
              <a:gd name="T6" fmla="*/ 9190 w 16143"/>
              <a:gd name="T7" fmla="*/ 1842 h 1842"/>
              <a:gd name="T8" fmla="*/ 9190 w 16143"/>
              <a:gd name="T9" fmla="*/ 763 h 1842"/>
              <a:gd name="T10" fmla="*/ 16143 w 16143"/>
              <a:gd name="T11" fmla="*/ 763 h 1842"/>
              <a:gd name="T12" fmla="*/ 16143 w 16143"/>
              <a:gd name="T13" fmla="*/ 0 h 1842"/>
              <a:gd name="T14" fmla="*/ 0 w 16143"/>
              <a:gd name="T15" fmla="*/ 0 h 18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6143" h="1842">
                <a:moveTo>
                  <a:pt x="0" y="0"/>
                </a:moveTo>
                <a:lnTo>
                  <a:pt x="0" y="921"/>
                </a:lnTo>
                <a:lnTo>
                  <a:pt x="0" y="1842"/>
                </a:lnTo>
                <a:lnTo>
                  <a:pt x="9190" y="1842"/>
                </a:lnTo>
                <a:lnTo>
                  <a:pt x="9190" y="763"/>
                </a:lnTo>
                <a:lnTo>
                  <a:pt x="16143" y="763"/>
                </a:lnTo>
                <a:lnTo>
                  <a:pt x="16143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5" name="Freeform 23"/>
          <p:cNvSpPr>
            <a:spLocks/>
          </p:cNvSpPr>
          <p:nvPr/>
        </p:nvSpPr>
        <p:spPr bwMode="auto">
          <a:xfrm>
            <a:off x="5938838" y="2771775"/>
            <a:ext cx="1885950" cy="781050"/>
          </a:xfrm>
          <a:custGeom>
            <a:avLst/>
            <a:gdLst>
              <a:gd name="T0" fmla="*/ 0 w 6953"/>
              <a:gd name="T1" fmla="*/ 0 h 2157"/>
              <a:gd name="T2" fmla="*/ 0 w 6953"/>
              <a:gd name="T3" fmla="*/ 1079 h 2157"/>
              <a:gd name="T4" fmla="*/ 0 w 6953"/>
              <a:gd name="T5" fmla="*/ 2157 h 2157"/>
              <a:gd name="T6" fmla="*/ 1874 w 6953"/>
              <a:gd name="T7" fmla="*/ 2157 h 2157"/>
              <a:gd name="T8" fmla="*/ 1874 w 6953"/>
              <a:gd name="T9" fmla="*/ 763 h 2157"/>
              <a:gd name="T10" fmla="*/ 6953 w 6953"/>
              <a:gd name="T11" fmla="*/ 763 h 2157"/>
              <a:gd name="T12" fmla="*/ 6953 w 6953"/>
              <a:gd name="T13" fmla="*/ 0 h 2157"/>
              <a:gd name="T14" fmla="*/ 0 w 6953"/>
              <a:gd name="T15" fmla="*/ 0 h 2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6953" h="2157">
                <a:moveTo>
                  <a:pt x="0" y="0"/>
                </a:moveTo>
                <a:lnTo>
                  <a:pt x="0" y="1079"/>
                </a:lnTo>
                <a:lnTo>
                  <a:pt x="0" y="2157"/>
                </a:lnTo>
                <a:lnTo>
                  <a:pt x="1874" y="2157"/>
                </a:lnTo>
                <a:lnTo>
                  <a:pt x="1874" y="763"/>
                </a:lnTo>
                <a:lnTo>
                  <a:pt x="6953" y="763"/>
                </a:lnTo>
                <a:lnTo>
                  <a:pt x="6953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6" name="Freeform 24"/>
          <p:cNvSpPr>
            <a:spLocks/>
          </p:cNvSpPr>
          <p:nvPr/>
        </p:nvSpPr>
        <p:spPr bwMode="auto">
          <a:xfrm>
            <a:off x="1011238" y="1666875"/>
            <a:ext cx="6813550" cy="566738"/>
          </a:xfrm>
          <a:custGeom>
            <a:avLst/>
            <a:gdLst>
              <a:gd name="T0" fmla="*/ 0 w 25116"/>
              <a:gd name="T1" fmla="*/ 0 h 1565"/>
              <a:gd name="T2" fmla="*/ 0 w 25116"/>
              <a:gd name="T3" fmla="*/ 783 h 1565"/>
              <a:gd name="T4" fmla="*/ 0 w 25116"/>
              <a:gd name="T5" fmla="*/ 1565 h 1565"/>
              <a:gd name="T6" fmla="*/ 2953 w 25116"/>
              <a:gd name="T7" fmla="*/ 1565 h 1565"/>
              <a:gd name="T8" fmla="*/ 2953 w 25116"/>
              <a:gd name="T9" fmla="*/ 763 h 1565"/>
              <a:gd name="T10" fmla="*/ 25116 w 25116"/>
              <a:gd name="T11" fmla="*/ 763 h 1565"/>
              <a:gd name="T12" fmla="*/ 25116 w 25116"/>
              <a:gd name="T13" fmla="*/ 0 h 1565"/>
              <a:gd name="T14" fmla="*/ 0 w 25116"/>
              <a:gd name="T15" fmla="*/ 0 h 15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5116" h="1565">
                <a:moveTo>
                  <a:pt x="0" y="0"/>
                </a:moveTo>
                <a:lnTo>
                  <a:pt x="0" y="783"/>
                </a:lnTo>
                <a:lnTo>
                  <a:pt x="0" y="1565"/>
                </a:lnTo>
                <a:lnTo>
                  <a:pt x="2953" y="1565"/>
                </a:lnTo>
                <a:lnTo>
                  <a:pt x="2953" y="763"/>
                </a:lnTo>
                <a:lnTo>
                  <a:pt x="25116" y="763"/>
                </a:lnTo>
                <a:lnTo>
                  <a:pt x="25116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7" name="Freeform 25"/>
          <p:cNvSpPr>
            <a:spLocks/>
          </p:cNvSpPr>
          <p:nvPr/>
        </p:nvSpPr>
        <p:spPr bwMode="auto">
          <a:xfrm>
            <a:off x="2151063" y="838200"/>
            <a:ext cx="5673725" cy="414338"/>
          </a:xfrm>
          <a:custGeom>
            <a:avLst/>
            <a:gdLst>
              <a:gd name="T0" fmla="*/ 0 w 20914"/>
              <a:gd name="T1" fmla="*/ 0 h 1144"/>
              <a:gd name="T2" fmla="*/ 0 w 20914"/>
              <a:gd name="T3" fmla="*/ 572 h 1144"/>
              <a:gd name="T4" fmla="*/ 0 w 20914"/>
              <a:gd name="T5" fmla="*/ 1144 h 1144"/>
              <a:gd name="T6" fmla="*/ 2434 w 20914"/>
              <a:gd name="T7" fmla="*/ 1144 h 1144"/>
              <a:gd name="T8" fmla="*/ 2434 w 20914"/>
              <a:gd name="T9" fmla="*/ 763 h 1144"/>
              <a:gd name="T10" fmla="*/ 20914 w 20914"/>
              <a:gd name="T11" fmla="*/ 763 h 1144"/>
              <a:gd name="T12" fmla="*/ 20914 w 20914"/>
              <a:gd name="T13" fmla="*/ 0 h 1144"/>
              <a:gd name="T14" fmla="*/ 0 w 20914"/>
              <a:gd name="T15" fmla="*/ 0 h 1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0914" h="1144">
                <a:moveTo>
                  <a:pt x="0" y="0"/>
                </a:moveTo>
                <a:lnTo>
                  <a:pt x="0" y="572"/>
                </a:lnTo>
                <a:lnTo>
                  <a:pt x="0" y="1144"/>
                </a:lnTo>
                <a:lnTo>
                  <a:pt x="2434" y="1144"/>
                </a:lnTo>
                <a:lnTo>
                  <a:pt x="2434" y="763"/>
                </a:lnTo>
                <a:lnTo>
                  <a:pt x="20914" y="763"/>
                </a:lnTo>
                <a:lnTo>
                  <a:pt x="20914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8" name="Freeform 26"/>
          <p:cNvSpPr>
            <a:spLocks/>
          </p:cNvSpPr>
          <p:nvPr/>
        </p:nvSpPr>
        <p:spPr bwMode="auto">
          <a:xfrm>
            <a:off x="6796088" y="4979988"/>
            <a:ext cx="1028700" cy="414338"/>
          </a:xfrm>
          <a:custGeom>
            <a:avLst/>
            <a:gdLst>
              <a:gd name="T0" fmla="*/ 0 w 3796"/>
              <a:gd name="T1" fmla="*/ 0 h 1144"/>
              <a:gd name="T2" fmla="*/ 0 w 3796"/>
              <a:gd name="T3" fmla="*/ 572 h 1144"/>
              <a:gd name="T4" fmla="*/ 0 w 3796"/>
              <a:gd name="T5" fmla="*/ 1144 h 1144"/>
              <a:gd name="T6" fmla="*/ 41 w 3796"/>
              <a:gd name="T7" fmla="*/ 1144 h 1144"/>
              <a:gd name="T8" fmla="*/ 41 w 3796"/>
              <a:gd name="T9" fmla="*/ 763 h 1144"/>
              <a:gd name="T10" fmla="*/ 3796 w 3796"/>
              <a:gd name="T11" fmla="*/ 763 h 1144"/>
              <a:gd name="T12" fmla="*/ 3796 w 3796"/>
              <a:gd name="T13" fmla="*/ 0 h 1144"/>
              <a:gd name="T14" fmla="*/ 0 w 3796"/>
              <a:gd name="T15" fmla="*/ 0 h 11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796" h="1144">
                <a:moveTo>
                  <a:pt x="0" y="0"/>
                </a:moveTo>
                <a:lnTo>
                  <a:pt x="0" y="572"/>
                </a:lnTo>
                <a:lnTo>
                  <a:pt x="0" y="1144"/>
                </a:lnTo>
                <a:lnTo>
                  <a:pt x="41" y="1144"/>
                </a:lnTo>
                <a:lnTo>
                  <a:pt x="41" y="763"/>
                </a:lnTo>
                <a:lnTo>
                  <a:pt x="3796" y="763"/>
                </a:lnTo>
                <a:lnTo>
                  <a:pt x="3796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9" name="Freeform 27"/>
          <p:cNvSpPr>
            <a:spLocks/>
          </p:cNvSpPr>
          <p:nvPr/>
        </p:nvSpPr>
        <p:spPr bwMode="auto">
          <a:xfrm>
            <a:off x="1811338" y="1943100"/>
            <a:ext cx="6013450" cy="581025"/>
          </a:xfrm>
          <a:custGeom>
            <a:avLst/>
            <a:gdLst>
              <a:gd name="T0" fmla="*/ 0 w 22163"/>
              <a:gd name="T1" fmla="*/ 0 h 1604"/>
              <a:gd name="T2" fmla="*/ 0 w 22163"/>
              <a:gd name="T3" fmla="*/ 802 h 1604"/>
              <a:gd name="T4" fmla="*/ 0 w 22163"/>
              <a:gd name="T5" fmla="*/ 1604 h 1604"/>
              <a:gd name="T6" fmla="*/ 2193 w 22163"/>
              <a:gd name="T7" fmla="*/ 1604 h 1604"/>
              <a:gd name="T8" fmla="*/ 2193 w 22163"/>
              <a:gd name="T9" fmla="*/ 763 h 1604"/>
              <a:gd name="T10" fmla="*/ 22163 w 22163"/>
              <a:gd name="T11" fmla="*/ 763 h 1604"/>
              <a:gd name="T12" fmla="*/ 22163 w 22163"/>
              <a:gd name="T13" fmla="*/ 0 h 1604"/>
              <a:gd name="T14" fmla="*/ 0 w 22163"/>
              <a:gd name="T15" fmla="*/ 0 h 16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22163" h="1604">
                <a:moveTo>
                  <a:pt x="0" y="0"/>
                </a:moveTo>
                <a:lnTo>
                  <a:pt x="0" y="802"/>
                </a:lnTo>
                <a:lnTo>
                  <a:pt x="0" y="1604"/>
                </a:lnTo>
                <a:lnTo>
                  <a:pt x="2193" y="1604"/>
                </a:lnTo>
                <a:lnTo>
                  <a:pt x="2193" y="763"/>
                </a:lnTo>
                <a:lnTo>
                  <a:pt x="22163" y="763"/>
                </a:lnTo>
                <a:lnTo>
                  <a:pt x="22163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0" name="Freeform 28"/>
          <p:cNvSpPr>
            <a:spLocks/>
          </p:cNvSpPr>
          <p:nvPr/>
        </p:nvSpPr>
        <p:spPr bwMode="auto">
          <a:xfrm>
            <a:off x="1031875" y="425450"/>
            <a:ext cx="6792913" cy="620713"/>
          </a:xfrm>
          <a:custGeom>
            <a:avLst/>
            <a:gdLst>
              <a:gd name="T0" fmla="*/ 0 w 25036"/>
              <a:gd name="T1" fmla="*/ 0 h 1716"/>
              <a:gd name="T2" fmla="*/ 0 w 25036"/>
              <a:gd name="T3" fmla="*/ 858 h 1716"/>
              <a:gd name="T4" fmla="*/ 0 w 25036"/>
              <a:gd name="T5" fmla="*/ 1716 h 1716"/>
              <a:gd name="T6" fmla="*/ 4122 w 25036"/>
              <a:gd name="T7" fmla="*/ 1716 h 1716"/>
              <a:gd name="T8" fmla="*/ 4122 w 25036"/>
              <a:gd name="T9" fmla="*/ 1144 h 1716"/>
              <a:gd name="T10" fmla="*/ 25036 w 25036"/>
              <a:gd name="T11" fmla="*/ 1144 h 1716"/>
              <a:gd name="T12" fmla="*/ 25036 w 25036"/>
              <a:gd name="T13" fmla="*/ 381 h 1716"/>
              <a:gd name="T14" fmla="*/ 1584 w 25036"/>
              <a:gd name="T15" fmla="*/ 381 h 1716"/>
              <a:gd name="T16" fmla="*/ 1584 w 25036"/>
              <a:gd name="T17" fmla="*/ 0 h 1716"/>
              <a:gd name="T18" fmla="*/ 0 w 25036"/>
              <a:gd name="T19" fmla="*/ 0 h 17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25036" h="1716">
                <a:moveTo>
                  <a:pt x="0" y="0"/>
                </a:moveTo>
                <a:lnTo>
                  <a:pt x="0" y="858"/>
                </a:lnTo>
                <a:lnTo>
                  <a:pt x="0" y="1716"/>
                </a:lnTo>
                <a:lnTo>
                  <a:pt x="4122" y="1716"/>
                </a:lnTo>
                <a:lnTo>
                  <a:pt x="4122" y="1144"/>
                </a:lnTo>
                <a:lnTo>
                  <a:pt x="25036" y="1144"/>
                </a:lnTo>
                <a:lnTo>
                  <a:pt x="25036" y="381"/>
                </a:lnTo>
                <a:lnTo>
                  <a:pt x="1584" y="381"/>
                </a:lnTo>
                <a:lnTo>
                  <a:pt x="1584" y="0"/>
                </a:lnTo>
                <a:lnTo>
                  <a:pt x="0" y="0"/>
                </a:lnTo>
                <a:close/>
              </a:path>
            </a:pathLst>
          </a:custGeom>
          <a:noFill/>
          <a:ln w="4763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1" name="Freeform 29"/>
          <p:cNvSpPr>
            <a:spLocks/>
          </p:cNvSpPr>
          <p:nvPr/>
        </p:nvSpPr>
        <p:spPr bwMode="auto">
          <a:xfrm>
            <a:off x="6545263" y="4057650"/>
            <a:ext cx="163513" cy="595313"/>
          </a:xfrm>
          <a:custGeom>
            <a:avLst/>
            <a:gdLst>
              <a:gd name="T0" fmla="*/ 604 w 604"/>
              <a:gd name="T1" fmla="*/ 1645 h 1645"/>
              <a:gd name="T2" fmla="*/ 0 w 604"/>
              <a:gd name="T3" fmla="*/ 1645 h 1645"/>
              <a:gd name="T4" fmla="*/ 0 w 604"/>
              <a:gd name="T5" fmla="*/ 0 h 16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04" h="1645">
                <a:moveTo>
                  <a:pt x="604" y="1645"/>
                </a:moveTo>
                <a:lnTo>
                  <a:pt x="0" y="1645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2" name="Freeform 30"/>
          <p:cNvSpPr>
            <a:spLocks/>
          </p:cNvSpPr>
          <p:nvPr/>
        </p:nvSpPr>
        <p:spPr bwMode="auto">
          <a:xfrm>
            <a:off x="5938838" y="3162300"/>
            <a:ext cx="508000" cy="390525"/>
          </a:xfrm>
          <a:custGeom>
            <a:avLst/>
            <a:gdLst>
              <a:gd name="T0" fmla="*/ 1874 w 1874"/>
              <a:gd name="T1" fmla="*/ 1078 h 1078"/>
              <a:gd name="T2" fmla="*/ 0 w 1874"/>
              <a:gd name="T3" fmla="*/ 1078 h 1078"/>
              <a:gd name="T4" fmla="*/ 0 w 1874"/>
              <a:gd name="T5" fmla="*/ 0 h 10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74" h="1078">
                <a:moveTo>
                  <a:pt x="1874" y="1078"/>
                </a:moveTo>
                <a:lnTo>
                  <a:pt x="0" y="1078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3" name="Freeform 31"/>
          <p:cNvSpPr>
            <a:spLocks/>
          </p:cNvSpPr>
          <p:nvPr/>
        </p:nvSpPr>
        <p:spPr bwMode="auto">
          <a:xfrm>
            <a:off x="6545263" y="3462338"/>
            <a:ext cx="0" cy="595313"/>
          </a:xfrm>
          <a:custGeom>
            <a:avLst/>
            <a:gdLst>
              <a:gd name="T0" fmla="*/ 0 h 1644"/>
              <a:gd name="T1" fmla="*/ 0 h 1644"/>
              <a:gd name="T2" fmla="*/ 1644 h 1644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1644">
                <a:moveTo>
                  <a:pt x="0" y="0"/>
                </a:moveTo>
                <a:lnTo>
                  <a:pt x="0" y="0"/>
                </a:lnTo>
                <a:lnTo>
                  <a:pt x="0" y="1644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4" name="Freeform 32"/>
          <p:cNvSpPr>
            <a:spLocks/>
          </p:cNvSpPr>
          <p:nvPr/>
        </p:nvSpPr>
        <p:spPr bwMode="auto">
          <a:xfrm>
            <a:off x="6446838" y="3552825"/>
            <a:ext cx="98425" cy="504825"/>
          </a:xfrm>
          <a:custGeom>
            <a:avLst/>
            <a:gdLst>
              <a:gd name="T0" fmla="*/ 359 w 359"/>
              <a:gd name="T1" fmla="*/ 1394 h 1394"/>
              <a:gd name="T2" fmla="*/ 0 w 359"/>
              <a:gd name="T3" fmla="*/ 1394 h 1394"/>
              <a:gd name="T4" fmla="*/ 0 w 359"/>
              <a:gd name="T5" fmla="*/ 0 h 13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9" h="1394">
                <a:moveTo>
                  <a:pt x="359" y="1394"/>
                </a:moveTo>
                <a:lnTo>
                  <a:pt x="0" y="1394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5" name="Freeform 33"/>
          <p:cNvSpPr>
            <a:spLocks/>
          </p:cNvSpPr>
          <p:nvPr/>
        </p:nvSpPr>
        <p:spPr bwMode="auto">
          <a:xfrm>
            <a:off x="6859588" y="4567238"/>
            <a:ext cx="0" cy="136525"/>
          </a:xfrm>
          <a:custGeom>
            <a:avLst/>
            <a:gdLst>
              <a:gd name="T0" fmla="*/ 381 h 381"/>
              <a:gd name="T1" fmla="*/ 381 h 381"/>
              <a:gd name="T2" fmla="*/ 0 h 38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1">
                <a:moveTo>
                  <a:pt x="0" y="381"/>
                </a:moveTo>
                <a:lnTo>
                  <a:pt x="0" y="38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6" name="Freeform 34"/>
          <p:cNvSpPr>
            <a:spLocks/>
          </p:cNvSpPr>
          <p:nvPr/>
        </p:nvSpPr>
        <p:spPr bwMode="auto">
          <a:xfrm>
            <a:off x="6791325" y="4117975"/>
            <a:ext cx="68263" cy="241300"/>
          </a:xfrm>
          <a:custGeom>
            <a:avLst/>
            <a:gdLst>
              <a:gd name="T0" fmla="*/ 253 w 253"/>
              <a:gd name="T1" fmla="*/ 668 h 668"/>
              <a:gd name="T2" fmla="*/ 0 w 253"/>
              <a:gd name="T3" fmla="*/ 668 h 668"/>
              <a:gd name="T4" fmla="*/ 0 w 253"/>
              <a:gd name="T5" fmla="*/ 0 h 6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3" h="668">
                <a:moveTo>
                  <a:pt x="253" y="668"/>
                </a:moveTo>
                <a:lnTo>
                  <a:pt x="0" y="668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7" name="Freeform 35"/>
          <p:cNvSpPr>
            <a:spLocks/>
          </p:cNvSpPr>
          <p:nvPr/>
        </p:nvSpPr>
        <p:spPr bwMode="auto">
          <a:xfrm>
            <a:off x="6807200" y="5394325"/>
            <a:ext cx="11113" cy="138113"/>
          </a:xfrm>
          <a:custGeom>
            <a:avLst/>
            <a:gdLst>
              <a:gd name="T0" fmla="*/ 41 w 41"/>
              <a:gd name="T1" fmla="*/ 381 h 381"/>
              <a:gd name="T2" fmla="*/ 0 w 41"/>
              <a:gd name="T3" fmla="*/ 381 h 381"/>
              <a:gd name="T4" fmla="*/ 0 w 41"/>
              <a:gd name="T5" fmla="*/ 0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" h="381">
                <a:moveTo>
                  <a:pt x="41" y="381"/>
                </a:moveTo>
                <a:lnTo>
                  <a:pt x="0" y="38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8" name="Freeform 36"/>
          <p:cNvSpPr>
            <a:spLocks/>
          </p:cNvSpPr>
          <p:nvPr/>
        </p:nvSpPr>
        <p:spPr bwMode="auto">
          <a:xfrm>
            <a:off x="109538" y="1343025"/>
            <a:ext cx="309563" cy="2405063"/>
          </a:xfrm>
          <a:custGeom>
            <a:avLst/>
            <a:gdLst>
              <a:gd name="T0" fmla="*/ 1141 w 1141"/>
              <a:gd name="T1" fmla="*/ 0 h 6645"/>
              <a:gd name="T2" fmla="*/ 0 w 1141"/>
              <a:gd name="T3" fmla="*/ 0 h 6645"/>
              <a:gd name="T4" fmla="*/ 0 w 1141"/>
              <a:gd name="T5" fmla="*/ 6645 h 66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41" h="6645">
                <a:moveTo>
                  <a:pt x="1141" y="0"/>
                </a:moveTo>
                <a:lnTo>
                  <a:pt x="0" y="0"/>
                </a:lnTo>
                <a:lnTo>
                  <a:pt x="0" y="6645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9" name="Freeform 37"/>
          <p:cNvSpPr>
            <a:spLocks/>
          </p:cNvSpPr>
          <p:nvPr/>
        </p:nvSpPr>
        <p:spPr bwMode="auto">
          <a:xfrm>
            <a:off x="1681163" y="6154738"/>
            <a:ext cx="5588000" cy="206375"/>
          </a:xfrm>
          <a:custGeom>
            <a:avLst/>
            <a:gdLst>
              <a:gd name="T0" fmla="*/ 20591 w 20591"/>
              <a:gd name="T1" fmla="*/ 573 h 573"/>
              <a:gd name="T2" fmla="*/ 0 w 20591"/>
              <a:gd name="T3" fmla="*/ 573 h 573"/>
              <a:gd name="T4" fmla="*/ 0 w 20591"/>
              <a:gd name="T5" fmla="*/ 0 h 57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591" h="573">
                <a:moveTo>
                  <a:pt x="20591" y="573"/>
                </a:moveTo>
                <a:lnTo>
                  <a:pt x="0" y="573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0" name="Freeform 38"/>
          <p:cNvSpPr>
            <a:spLocks/>
          </p:cNvSpPr>
          <p:nvPr/>
        </p:nvSpPr>
        <p:spPr bwMode="auto">
          <a:xfrm>
            <a:off x="6796088" y="5187950"/>
            <a:ext cx="11113" cy="206375"/>
          </a:xfrm>
          <a:custGeom>
            <a:avLst/>
            <a:gdLst>
              <a:gd name="T0" fmla="*/ 41 w 41"/>
              <a:gd name="T1" fmla="*/ 572 h 572"/>
              <a:gd name="T2" fmla="*/ 0 w 41"/>
              <a:gd name="T3" fmla="*/ 572 h 572"/>
              <a:gd name="T4" fmla="*/ 0 w 41"/>
              <a:gd name="T5" fmla="*/ 0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" h="572">
                <a:moveTo>
                  <a:pt x="41" y="572"/>
                </a:moveTo>
                <a:lnTo>
                  <a:pt x="0" y="57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1" name="Freeform 39"/>
          <p:cNvSpPr>
            <a:spLocks/>
          </p:cNvSpPr>
          <p:nvPr/>
        </p:nvSpPr>
        <p:spPr bwMode="auto">
          <a:xfrm>
            <a:off x="3444875" y="2495550"/>
            <a:ext cx="3036888" cy="333375"/>
          </a:xfrm>
          <a:custGeom>
            <a:avLst/>
            <a:gdLst>
              <a:gd name="T0" fmla="*/ 11188 w 11188"/>
              <a:gd name="T1" fmla="*/ 0 h 921"/>
              <a:gd name="T2" fmla="*/ 0 w 11188"/>
              <a:gd name="T3" fmla="*/ 0 h 921"/>
              <a:gd name="T4" fmla="*/ 0 w 11188"/>
              <a:gd name="T5" fmla="*/ 921 h 9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188" h="921">
                <a:moveTo>
                  <a:pt x="11188" y="0"/>
                </a:moveTo>
                <a:lnTo>
                  <a:pt x="0" y="0"/>
                </a:lnTo>
                <a:lnTo>
                  <a:pt x="0" y="92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2" name="Freeform 40"/>
          <p:cNvSpPr>
            <a:spLocks/>
          </p:cNvSpPr>
          <p:nvPr/>
        </p:nvSpPr>
        <p:spPr bwMode="auto">
          <a:xfrm>
            <a:off x="6859588" y="4429125"/>
            <a:ext cx="0" cy="138113"/>
          </a:xfrm>
          <a:custGeom>
            <a:avLst/>
            <a:gdLst>
              <a:gd name="T0" fmla="*/ 0 h 382"/>
              <a:gd name="T1" fmla="*/ 0 h 382"/>
              <a:gd name="T2" fmla="*/ 382 h 38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2">
                <a:moveTo>
                  <a:pt x="0" y="0"/>
                </a:moveTo>
                <a:lnTo>
                  <a:pt x="0" y="0"/>
                </a:lnTo>
                <a:lnTo>
                  <a:pt x="0" y="38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3" name="Freeform 41"/>
          <p:cNvSpPr>
            <a:spLocks/>
          </p:cNvSpPr>
          <p:nvPr/>
        </p:nvSpPr>
        <p:spPr bwMode="auto">
          <a:xfrm>
            <a:off x="1681163" y="5946775"/>
            <a:ext cx="1736725" cy="207963"/>
          </a:xfrm>
          <a:custGeom>
            <a:avLst/>
            <a:gdLst>
              <a:gd name="T0" fmla="*/ 6397 w 6397"/>
              <a:gd name="T1" fmla="*/ 0 h 572"/>
              <a:gd name="T2" fmla="*/ 0 w 6397"/>
              <a:gd name="T3" fmla="*/ 0 h 572"/>
              <a:gd name="T4" fmla="*/ 0 w 6397"/>
              <a:gd name="T5" fmla="*/ 572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97" h="572">
                <a:moveTo>
                  <a:pt x="6397" y="0"/>
                </a:moveTo>
                <a:lnTo>
                  <a:pt x="0" y="0"/>
                </a:lnTo>
                <a:lnTo>
                  <a:pt x="0" y="57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4" name="Freeform 42"/>
          <p:cNvSpPr>
            <a:spLocks/>
          </p:cNvSpPr>
          <p:nvPr/>
        </p:nvSpPr>
        <p:spPr bwMode="auto">
          <a:xfrm>
            <a:off x="6708775" y="4117975"/>
            <a:ext cx="82550" cy="534988"/>
          </a:xfrm>
          <a:custGeom>
            <a:avLst/>
            <a:gdLst>
              <a:gd name="T0" fmla="*/ 306 w 306"/>
              <a:gd name="T1" fmla="*/ 0 h 1478"/>
              <a:gd name="T2" fmla="*/ 0 w 306"/>
              <a:gd name="T3" fmla="*/ 0 h 1478"/>
              <a:gd name="T4" fmla="*/ 0 w 306"/>
              <a:gd name="T5" fmla="*/ 1478 h 14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6" h="1478">
                <a:moveTo>
                  <a:pt x="306" y="0"/>
                </a:moveTo>
                <a:lnTo>
                  <a:pt x="0" y="0"/>
                </a:lnTo>
                <a:lnTo>
                  <a:pt x="0" y="1478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5" name="Freeform 43"/>
          <p:cNvSpPr>
            <a:spLocks/>
          </p:cNvSpPr>
          <p:nvPr/>
        </p:nvSpPr>
        <p:spPr bwMode="auto">
          <a:xfrm>
            <a:off x="5938838" y="2771775"/>
            <a:ext cx="209550" cy="390525"/>
          </a:xfrm>
          <a:custGeom>
            <a:avLst/>
            <a:gdLst>
              <a:gd name="T0" fmla="*/ 771 w 771"/>
              <a:gd name="T1" fmla="*/ 0 h 1079"/>
              <a:gd name="T2" fmla="*/ 0 w 771"/>
              <a:gd name="T3" fmla="*/ 0 h 1079"/>
              <a:gd name="T4" fmla="*/ 0 w 771"/>
              <a:gd name="T5" fmla="*/ 1079 h 10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1" h="1079">
                <a:moveTo>
                  <a:pt x="771" y="0"/>
                </a:moveTo>
                <a:lnTo>
                  <a:pt x="0" y="0"/>
                </a:lnTo>
                <a:lnTo>
                  <a:pt x="0" y="1079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6" name="Freeform 44"/>
          <p:cNvSpPr>
            <a:spLocks/>
          </p:cNvSpPr>
          <p:nvPr/>
        </p:nvSpPr>
        <p:spPr bwMode="auto">
          <a:xfrm>
            <a:off x="6796088" y="4979988"/>
            <a:ext cx="0" cy="207963"/>
          </a:xfrm>
          <a:custGeom>
            <a:avLst/>
            <a:gdLst>
              <a:gd name="T0" fmla="*/ 0 h 572"/>
              <a:gd name="T1" fmla="*/ 0 h 572"/>
              <a:gd name="T2" fmla="*/ 572 h 5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2">
                <a:moveTo>
                  <a:pt x="0" y="0"/>
                </a:moveTo>
                <a:lnTo>
                  <a:pt x="0" y="0"/>
                </a:lnTo>
                <a:lnTo>
                  <a:pt x="0" y="57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7" name="Freeform 45"/>
          <p:cNvSpPr>
            <a:spLocks/>
          </p:cNvSpPr>
          <p:nvPr/>
        </p:nvSpPr>
        <p:spPr bwMode="auto">
          <a:xfrm>
            <a:off x="1811338" y="2233613"/>
            <a:ext cx="595313" cy="290513"/>
          </a:xfrm>
          <a:custGeom>
            <a:avLst/>
            <a:gdLst>
              <a:gd name="T0" fmla="*/ 2193 w 2193"/>
              <a:gd name="T1" fmla="*/ 802 h 802"/>
              <a:gd name="T2" fmla="*/ 0 w 2193"/>
              <a:gd name="T3" fmla="*/ 802 h 802"/>
              <a:gd name="T4" fmla="*/ 0 w 2193"/>
              <a:gd name="T5" fmla="*/ 0 h 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93" h="802">
                <a:moveTo>
                  <a:pt x="2193" y="802"/>
                </a:moveTo>
                <a:lnTo>
                  <a:pt x="0" y="80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8" name="Freeform 46"/>
          <p:cNvSpPr>
            <a:spLocks/>
          </p:cNvSpPr>
          <p:nvPr/>
        </p:nvSpPr>
        <p:spPr bwMode="auto">
          <a:xfrm>
            <a:off x="2406650" y="2524125"/>
            <a:ext cx="1038225" cy="304800"/>
          </a:xfrm>
          <a:custGeom>
            <a:avLst/>
            <a:gdLst>
              <a:gd name="T0" fmla="*/ 3827 w 3827"/>
              <a:gd name="T1" fmla="*/ 842 h 842"/>
              <a:gd name="T2" fmla="*/ 0 w 3827"/>
              <a:gd name="T3" fmla="*/ 842 h 842"/>
              <a:gd name="T4" fmla="*/ 0 w 3827"/>
              <a:gd name="T5" fmla="*/ 0 h 84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27" h="842">
                <a:moveTo>
                  <a:pt x="3827" y="842"/>
                </a:moveTo>
                <a:lnTo>
                  <a:pt x="0" y="84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9" name="Freeform 47"/>
          <p:cNvSpPr>
            <a:spLocks/>
          </p:cNvSpPr>
          <p:nvPr/>
        </p:nvSpPr>
        <p:spPr bwMode="auto">
          <a:xfrm>
            <a:off x="3444875" y="2828925"/>
            <a:ext cx="2493963" cy="333375"/>
          </a:xfrm>
          <a:custGeom>
            <a:avLst/>
            <a:gdLst>
              <a:gd name="T0" fmla="*/ 9190 w 9190"/>
              <a:gd name="T1" fmla="*/ 921 h 921"/>
              <a:gd name="T2" fmla="*/ 0 w 9190"/>
              <a:gd name="T3" fmla="*/ 921 h 921"/>
              <a:gd name="T4" fmla="*/ 0 w 9190"/>
              <a:gd name="T5" fmla="*/ 0 h 9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190" h="921">
                <a:moveTo>
                  <a:pt x="9190" y="921"/>
                </a:moveTo>
                <a:lnTo>
                  <a:pt x="0" y="92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0" name="Freeform 48"/>
          <p:cNvSpPr>
            <a:spLocks/>
          </p:cNvSpPr>
          <p:nvPr/>
        </p:nvSpPr>
        <p:spPr bwMode="auto">
          <a:xfrm>
            <a:off x="419100" y="1343025"/>
            <a:ext cx="592138" cy="608013"/>
          </a:xfrm>
          <a:custGeom>
            <a:avLst/>
            <a:gdLst>
              <a:gd name="T0" fmla="*/ 2179 w 2179"/>
              <a:gd name="T1" fmla="*/ 1679 h 1679"/>
              <a:gd name="T2" fmla="*/ 0 w 2179"/>
              <a:gd name="T3" fmla="*/ 1679 h 1679"/>
              <a:gd name="T4" fmla="*/ 0 w 2179"/>
              <a:gd name="T5" fmla="*/ 0 h 16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9" h="1679">
                <a:moveTo>
                  <a:pt x="2179" y="1679"/>
                </a:moveTo>
                <a:lnTo>
                  <a:pt x="0" y="1679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1" name="Freeform 49"/>
          <p:cNvSpPr>
            <a:spLocks/>
          </p:cNvSpPr>
          <p:nvPr/>
        </p:nvSpPr>
        <p:spPr bwMode="auto">
          <a:xfrm>
            <a:off x="6859588" y="4152900"/>
            <a:ext cx="0" cy="206375"/>
          </a:xfrm>
          <a:custGeom>
            <a:avLst/>
            <a:gdLst>
              <a:gd name="T0" fmla="*/ 0 h 572"/>
              <a:gd name="T1" fmla="*/ 0 h 572"/>
              <a:gd name="T2" fmla="*/ 572 h 5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2">
                <a:moveTo>
                  <a:pt x="0" y="0"/>
                </a:moveTo>
                <a:lnTo>
                  <a:pt x="0" y="0"/>
                </a:lnTo>
                <a:lnTo>
                  <a:pt x="0" y="57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2" name="Freeform 50"/>
          <p:cNvSpPr>
            <a:spLocks/>
          </p:cNvSpPr>
          <p:nvPr/>
        </p:nvSpPr>
        <p:spPr bwMode="auto">
          <a:xfrm>
            <a:off x="1011238" y="1951038"/>
            <a:ext cx="800100" cy="282575"/>
          </a:xfrm>
          <a:custGeom>
            <a:avLst/>
            <a:gdLst>
              <a:gd name="T0" fmla="*/ 2953 w 2953"/>
              <a:gd name="T1" fmla="*/ 782 h 782"/>
              <a:gd name="T2" fmla="*/ 0 w 2953"/>
              <a:gd name="T3" fmla="*/ 782 h 782"/>
              <a:gd name="T4" fmla="*/ 0 w 2953"/>
              <a:gd name="T5" fmla="*/ 0 h 7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53" h="782">
                <a:moveTo>
                  <a:pt x="2953" y="782"/>
                </a:moveTo>
                <a:lnTo>
                  <a:pt x="0" y="78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3" name="Freeform 51"/>
          <p:cNvSpPr>
            <a:spLocks/>
          </p:cNvSpPr>
          <p:nvPr/>
        </p:nvSpPr>
        <p:spPr bwMode="auto">
          <a:xfrm>
            <a:off x="419100" y="735013"/>
            <a:ext cx="612775" cy="608013"/>
          </a:xfrm>
          <a:custGeom>
            <a:avLst/>
            <a:gdLst>
              <a:gd name="T0" fmla="*/ 2259 w 2259"/>
              <a:gd name="T1" fmla="*/ 0 h 1678"/>
              <a:gd name="T2" fmla="*/ 0 w 2259"/>
              <a:gd name="T3" fmla="*/ 0 h 1678"/>
              <a:gd name="T4" fmla="*/ 0 w 2259"/>
              <a:gd name="T5" fmla="*/ 1678 h 16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59" h="1678">
                <a:moveTo>
                  <a:pt x="2259" y="0"/>
                </a:moveTo>
                <a:lnTo>
                  <a:pt x="0" y="0"/>
                </a:lnTo>
                <a:lnTo>
                  <a:pt x="0" y="1678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4" name="Freeform 52"/>
          <p:cNvSpPr>
            <a:spLocks/>
          </p:cNvSpPr>
          <p:nvPr/>
        </p:nvSpPr>
        <p:spPr bwMode="auto">
          <a:xfrm>
            <a:off x="1811338" y="1943100"/>
            <a:ext cx="3917950" cy="290513"/>
          </a:xfrm>
          <a:custGeom>
            <a:avLst/>
            <a:gdLst>
              <a:gd name="T0" fmla="*/ 14440 w 14440"/>
              <a:gd name="T1" fmla="*/ 0 h 802"/>
              <a:gd name="T2" fmla="*/ 0 w 14440"/>
              <a:gd name="T3" fmla="*/ 0 h 802"/>
              <a:gd name="T4" fmla="*/ 0 w 14440"/>
              <a:gd name="T5" fmla="*/ 802 h 80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440" h="802">
                <a:moveTo>
                  <a:pt x="14440" y="0"/>
                </a:moveTo>
                <a:lnTo>
                  <a:pt x="0" y="0"/>
                </a:lnTo>
                <a:lnTo>
                  <a:pt x="0" y="80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5" name="Freeform 53"/>
          <p:cNvSpPr>
            <a:spLocks/>
          </p:cNvSpPr>
          <p:nvPr/>
        </p:nvSpPr>
        <p:spPr bwMode="auto">
          <a:xfrm>
            <a:off x="2811463" y="1252538"/>
            <a:ext cx="2147888" cy="138113"/>
          </a:xfrm>
          <a:custGeom>
            <a:avLst/>
            <a:gdLst>
              <a:gd name="T0" fmla="*/ 7917 w 7917"/>
              <a:gd name="T1" fmla="*/ 381 h 381"/>
              <a:gd name="T2" fmla="*/ 0 w 7917"/>
              <a:gd name="T3" fmla="*/ 381 h 381"/>
              <a:gd name="T4" fmla="*/ 0 w 7917"/>
              <a:gd name="T5" fmla="*/ 0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17" h="381">
                <a:moveTo>
                  <a:pt x="7917" y="381"/>
                </a:moveTo>
                <a:lnTo>
                  <a:pt x="0" y="38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6" name="Freeform 54"/>
          <p:cNvSpPr>
            <a:spLocks/>
          </p:cNvSpPr>
          <p:nvPr/>
        </p:nvSpPr>
        <p:spPr bwMode="auto">
          <a:xfrm>
            <a:off x="6791325" y="3876675"/>
            <a:ext cx="47625" cy="241300"/>
          </a:xfrm>
          <a:custGeom>
            <a:avLst/>
            <a:gdLst>
              <a:gd name="T0" fmla="*/ 173 w 173"/>
              <a:gd name="T1" fmla="*/ 0 h 667"/>
              <a:gd name="T2" fmla="*/ 0 w 173"/>
              <a:gd name="T3" fmla="*/ 0 h 667"/>
              <a:gd name="T4" fmla="*/ 0 w 173"/>
              <a:gd name="T5" fmla="*/ 667 h 6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3" h="667">
                <a:moveTo>
                  <a:pt x="173" y="0"/>
                </a:moveTo>
                <a:lnTo>
                  <a:pt x="0" y="0"/>
                </a:lnTo>
                <a:lnTo>
                  <a:pt x="0" y="667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7" name="Freeform 55"/>
          <p:cNvSpPr>
            <a:spLocks/>
          </p:cNvSpPr>
          <p:nvPr/>
        </p:nvSpPr>
        <p:spPr bwMode="auto">
          <a:xfrm>
            <a:off x="6807200" y="5256213"/>
            <a:ext cx="0" cy="138113"/>
          </a:xfrm>
          <a:custGeom>
            <a:avLst/>
            <a:gdLst>
              <a:gd name="T0" fmla="*/ 0 h 381"/>
              <a:gd name="T1" fmla="*/ 0 h 381"/>
              <a:gd name="T2" fmla="*/ 381 h 38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1">
                <a:moveTo>
                  <a:pt x="0" y="0"/>
                </a:moveTo>
                <a:lnTo>
                  <a:pt x="0" y="0"/>
                </a:lnTo>
                <a:lnTo>
                  <a:pt x="0" y="38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8" name="Freeform 56"/>
          <p:cNvSpPr>
            <a:spLocks/>
          </p:cNvSpPr>
          <p:nvPr/>
        </p:nvSpPr>
        <p:spPr bwMode="auto">
          <a:xfrm>
            <a:off x="2151063" y="1046163"/>
            <a:ext cx="660400" cy="206375"/>
          </a:xfrm>
          <a:custGeom>
            <a:avLst/>
            <a:gdLst>
              <a:gd name="T0" fmla="*/ 2434 w 2434"/>
              <a:gd name="T1" fmla="*/ 572 h 572"/>
              <a:gd name="T2" fmla="*/ 0 w 2434"/>
              <a:gd name="T3" fmla="*/ 572 h 572"/>
              <a:gd name="T4" fmla="*/ 0 w 2434"/>
              <a:gd name="T5" fmla="*/ 0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34" h="572">
                <a:moveTo>
                  <a:pt x="2434" y="572"/>
                </a:moveTo>
                <a:lnTo>
                  <a:pt x="0" y="57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9" name="Freeform 57"/>
          <p:cNvSpPr>
            <a:spLocks/>
          </p:cNvSpPr>
          <p:nvPr/>
        </p:nvSpPr>
        <p:spPr bwMode="auto">
          <a:xfrm>
            <a:off x="6446838" y="3048000"/>
            <a:ext cx="217488" cy="504825"/>
          </a:xfrm>
          <a:custGeom>
            <a:avLst/>
            <a:gdLst>
              <a:gd name="T0" fmla="*/ 799 w 799"/>
              <a:gd name="T1" fmla="*/ 0 h 1394"/>
              <a:gd name="T2" fmla="*/ 0 w 799"/>
              <a:gd name="T3" fmla="*/ 0 h 1394"/>
              <a:gd name="T4" fmla="*/ 0 w 799"/>
              <a:gd name="T5" fmla="*/ 1394 h 13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9" h="1394">
                <a:moveTo>
                  <a:pt x="799" y="0"/>
                </a:moveTo>
                <a:lnTo>
                  <a:pt x="0" y="0"/>
                </a:lnTo>
                <a:lnTo>
                  <a:pt x="0" y="1394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0" name="Freeform 58"/>
          <p:cNvSpPr>
            <a:spLocks/>
          </p:cNvSpPr>
          <p:nvPr/>
        </p:nvSpPr>
        <p:spPr bwMode="auto">
          <a:xfrm>
            <a:off x="3417888" y="5808663"/>
            <a:ext cx="3278188" cy="138113"/>
          </a:xfrm>
          <a:custGeom>
            <a:avLst/>
            <a:gdLst>
              <a:gd name="T0" fmla="*/ 12081 w 12081"/>
              <a:gd name="T1" fmla="*/ 0 h 381"/>
              <a:gd name="T2" fmla="*/ 0 w 12081"/>
              <a:gd name="T3" fmla="*/ 0 h 381"/>
              <a:gd name="T4" fmla="*/ 0 w 12081"/>
              <a:gd name="T5" fmla="*/ 381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081" h="381">
                <a:moveTo>
                  <a:pt x="12081" y="0"/>
                </a:moveTo>
                <a:lnTo>
                  <a:pt x="0" y="0"/>
                </a:lnTo>
                <a:lnTo>
                  <a:pt x="0" y="38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1" name="Line 59"/>
          <p:cNvSpPr>
            <a:spLocks noChangeShapeType="1"/>
          </p:cNvSpPr>
          <p:nvPr/>
        </p:nvSpPr>
        <p:spPr bwMode="auto">
          <a:xfrm>
            <a:off x="33338" y="3748088"/>
            <a:ext cx="76200" cy="0"/>
          </a:xfrm>
          <a:prstGeom prst="line">
            <a:avLst/>
          </a:pr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2" name="Freeform 60"/>
          <p:cNvSpPr>
            <a:spLocks/>
          </p:cNvSpPr>
          <p:nvPr/>
        </p:nvSpPr>
        <p:spPr bwMode="auto">
          <a:xfrm>
            <a:off x="1031875" y="425450"/>
            <a:ext cx="430213" cy="309563"/>
          </a:xfrm>
          <a:custGeom>
            <a:avLst/>
            <a:gdLst>
              <a:gd name="T0" fmla="*/ 1584 w 1584"/>
              <a:gd name="T1" fmla="*/ 0 h 858"/>
              <a:gd name="T2" fmla="*/ 0 w 1584"/>
              <a:gd name="T3" fmla="*/ 0 h 858"/>
              <a:gd name="T4" fmla="*/ 0 w 1584"/>
              <a:gd name="T5" fmla="*/ 858 h 8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84" h="858">
                <a:moveTo>
                  <a:pt x="1584" y="0"/>
                </a:moveTo>
                <a:lnTo>
                  <a:pt x="0" y="0"/>
                </a:lnTo>
                <a:lnTo>
                  <a:pt x="0" y="858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3" name="Freeform 61"/>
          <p:cNvSpPr>
            <a:spLocks/>
          </p:cNvSpPr>
          <p:nvPr/>
        </p:nvSpPr>
        <p:spPr bwMode="auto">
          <a:xfrm>
            <a:off x="6545263" y="3324225"/>
            <a:ext cx="139700" cy="138113"/>
          </a:xfrm>
          <a:custGeom>
            <a:avLst/>
            <a:gdLst>
              <a:gd name="T0" fmla="*/ 518 w 518"/>
              <a:gd name="T1" fmla="*/ 0 h 381"/>
              <a:gd name="T2" fmla="*/ 0 w 518"/>
              <a:gd name="T3" fmla="*/ 0 h 381"/>
              <a:gd name="T4" fmla="*/ 0 w 518"/>
              <a:gd name="T5" fmla="*/ 381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8" h="381">
                <a:moveTo>
                  <a:pt x="518" y="0"/>
                </a:moveTo>
                <a:lnTo>
                  <a:pt x="0" y="0"/>
                </a:lnTo>
                <a:lnTo>
                  <a:pt x="0" y="38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4" name="Freeform 62"/>
          <p:cNvSpPr>
            <a:spLocks/>
          </p:cNvSpPr>
          <p:nvPr/>
        </p:nvSpPr>
        <p:spPr bwMode="auto">
          <a:xfrm>
            <a:off x="2811463" y="1114425"/>
            <a:ext cx="2249488" cy="138113"/>
          </a:xfrm>
          <a:custGeom>
            <a:avLst/>
            <a:gdLst>
              <a:gd name="T0" fmla="*/ 8291 w 8291"/>
              <a:gd name="T1" fmla="*/ 0 h 381"/>
              <a:gd name="T2" fmla="*/ 0 w 8291"/>
              <a:gd name="T3" fmla="*/ 0 h 381"/>
              <a:gd name="T4" fmla="*/ 0 w 8291"/>
              <a:gd name="T5" fmla="*/ 381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91" h="381">
                <a:moveTo>
                  <a:pt x="8291" y="0"/>
                </a:moveTo>
                <a:lnTo>
                  <a:pt x="0" y="0"/>
                </a:lnTo>
                <a:lnTo>
                  <a:pt x="0" y="38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5" name="Freeform 63"/>
          <p:cNvSpPr>
            <a:spLocks/>
          </p:cNvSpPr>
          <p:nvPr/>
        </p:nvSpPr>
        <p:spPr bwMode="auto">
          <a:xfrm>
            <a:off x="109538" y="3748088"/>
            <a:ext cx="1571625" cy="2406650"/>
          </a:xfrm>
          <a:custGeom>
            <a:avLst/>
            <a:gdLst>
              <a:gd name="T0" fmla="*/ 5793 w 5793"/>
              <a:gd name="T1" fmla="*/ 6645 h 6645"/>
              <a:gd name="T2" fmla="*/ 0 w 5793"/>
              <a:gd name="T3" fmla="*/ 6645 h 6645"/>
              <a:gd name="T4" fmla="*/ 0 w 5793"/>
              <a:gd name="T5" fmla="*/ 0 h 664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93" h="6645">
                <a:moveTo>
                  <a:pt x="5793" y="6645"/>
                </a:moveTo>
                <a:lnTo>
                  <a:pt x="0" y="6645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6" name="Freeform 64"/>
          <p:cNvSpPr>
            <a:spLocks/>
          </p:cNvSpPr>
          <p:nvPr/>
        </p:nvSpPr>
        <p:spPr bwMode="auto">
          <a:xfrm>
            <a:off x="6859588" y="4359275"/>
            <a:ext cx="0" cy="207963"/>
          </a:xfrm>
          <a:custGeom>
            <a:avLst/>
            <a:gdLst>
              <a:gd name="T0" fmla="*/ 572 h 572"/>
              <a:gd name="T1" fmla="*/ 572 h 572"/>
              <a:gd name="T2" fmla="*/ 0 h 572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72">
                <a:moveTo>
                  <a:pt x="0" y="572"/>
                </a:moveTo>
                <a:lnTo>
                  <a:pt x="0" y="57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7" name="Freeform 65"/>
          <p:cNvSpPr>
            <a:spLocks/>
          </p:cNvSpPr>
          <p:nvPr/>
        </p:nvSpPr>
        <p:spPr bwMode="auto">
          <a:xfrm>
            <a:off x="2151063" y="838200"/>
            <a:ext cx="5364163" cy="207963"/>
          </a:xfrm>
          <a:custGeom>
            <a:avLst/>
            <a:gdLst>
              <a:gd name="T0" fmla="*/ 19773 w 19773"/>
              <a:gd name="T1" fmla="*/ 0 h 572"/>
              <a:gd name="T2" fmla="*/ 0 w 19773"/>
              <a:gd name="T3" fmla="*/ 0 h 572"/>
              <a:gd name="T4" fmla="*/ 0 w 19773"/>
              <a:gd name="T5" fmla="*/ 572 h 57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73" h="572">
                <a:moveTo>
                  <a:pt x="19773" y="0"/>
                </a:moveTo>
                <a:lnTo>
                  <a:pt x="0" y="0"/>
                </a:lnTo>
                <a:lnTo>
                  <a:pt x="0" y="572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8" name="Freeform 66"/>
          <p:cNvSpPr>
            <a:spLocks/>
          </p:cNvSpPr>
          <p:nvPr/>
        </p:nvSpPr>
        <p:spPr bwMode="auto">
          <a:xfrm>
            <a:off x="6545263" y="3462338"/>
            <a:ext cx="0" cy="138113"/>
          </a:xfrm>
          <a:custGeom>
            <a:avLst/>
            <a:gdLst>
              <a:gd name="T0" fmla="*/ 381 h 381"/>
              <a:gd name="T1" fmla="*/ 381 h 381"/>
              <a:gd name="T2" fmla="*/ 0 h 381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81">
                <a:moveTo>
                  <a:pt x="0" y="381"/>
                </a:moveTo>
                <a:lnTo>
                  <a:pt x="0" y="38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9" name="Freeform 67"/>
          <p:cNvSpPr>
            <a:spLocks/>
          </p:cNvSpPr>
          <p:nvPr/>
        </p:nvSpPr>
        <p:spPr bwMode="auto">
          <a:xfrm>
            <a:off x="1462088" y="287338"/>
            <a:ext cx="5459413" cy="138113"/>
          </a:xfrm>
          <a:custGeom>
            <a:avLst/>
            <a:gdLst>
              <a:gd name="T0" fmla="*/ 20118 w 20118"/>
              <a:gd name="T1" fmla="*/ 0 h 381"/>
              <a:gd name="T2" fmla="*/ 0 w 20118"/>
              <a:gd name="T3" fmla="*/ 0 h 381"/>
              <a:gd name="T4" fmla="*/ 0 w 20118"/>
              <a:gd name="T5" fmla="*/ 381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118" h="381">
                <a:moveTo>
                  <a:pt x="20118" y="0"/>
                </a:moveTo>
                <a:lnTo>
                  <a:pt x="0" y="0"/>
                </a:lnTo>
                <a:lnTo>
                  <a:pt x="0" y="38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0" name="Freeform 68"/>
          <p:cNvSpPr>
            <a:spLocks/>
          </p:cNvSpPr>
          <p:nvPr/>
        </p:nvSpPr>
        <p:spPr bwMode="auto">
          <a:xfrm>
            <a:off x="2406650" y="2219325"/>
            <a:ext cx="4067175" cy="304800"/>
          </a:xfrm>
          <a:custGeom>
            <a:avLst/>
            <a:gdLst>
              <a:gd name="T0" fmla="*/ 14989 w 14989"/>
              <a:gd name="T1" fmla="*/ 0 h 841"/>
              <a:gd name="T2" fmla="*/ 0 w 14989"/>
              <a:gd name="T3" fmla="*/ 0 h 841"/>
              <a:gd name="T4" fmla="*/ 0 w 14989"/>
              <a:gd name="T5" fmla="*/ 841 h 8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989" h="841">
                <a:moveTo>
                  <a:pt x="14989" y="0"/>
                </a:moveTo>
                <a:lnTo>
                  <a:pt x="0" y="0"/>
                </a:lnTo>
                <a:lnTo>
                  <a:pt x="0" y="841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1" name="Freeform 69"/>
          <p:cNvSpPr>
            <a:spLocks/>
          </p:cNvSpPr>
          <p:nvPr/>
        </p:nvSpPr>
        <p:spPr bwMode="auto">
          <a:xfrm>
            <a:off x="1011238" y="1666875"/>
            <a:ext cx="4681538" cy="284163"/>
          </a:xfrm>
          <a:custGeom>
            <a:avLst/>
            <a:gdLst>
              <a:gd name="T0" fmla="*/ 17257 w 17257"/>
              <a:gd name="T1" fmla="*/ 0 h 783"/>
              <a:gd name="T2" fmla="*/ 0 w 17257"/>
              <a:gd name="T3" fmla="*/ 0 h 783"/>
              <a:gd name="T4" fmla="*/ 0 w 17257"/>
              <a:gd name="T5" fmla="*/ 783 h 7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257" h="783">
                <a:moveTo>
                  <a:pt x="17257" y="0"/>
                </a:moveTo>
                <a:lnTo>
                  <a:pt x="0" y="0"/>
                </a:lnTo>
                <a:lnTo>
                  <a:pt x="0" y="783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2" name="Freeform 70"/>
          <p:cNvSpPr>
            <a:spLocks/>
          </p:cNvSpPr>
          <p:nvPr/>
        </p:nvSpPr>
        <p:spPr bwMode="auto">
          <a:xfrm>
            <a:off x="1462088" y="425450"/>
            <a:ext cx="3967163" cy="136525"/>
          </a:xfrm>
          <a:custGeom>
            <a:avLst/>
            <a:gdLst>
              <a:gd name="T0" fmla="*/ 14620 w 14620"/>
              <a:gd name="T1" fmla="*/ 381 h 381"/>
              <a:gd name="T2" fmla="*/ 0 w 14620"/>
              <a:gd name="T3" fmla="*/ 381 h 381"/>
              <a:gd name="T4" fmla="*/ 0 w 14620"/>
              <a:gd name="T5" fmla="*/ 0 h 3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620" h="381">
                <a:moveTo>
                  <a:pt x="14620" y="381"/>
                </a:moveTo>
                <a:lnTo>
                  <a:pt x="0" y="381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3" name="Freeform 71"/>
          <p:cNvSpPr>
            <a:spLocks/>
          </p:cNvSpPr>
          <p:nvPr/>
        </p:nvSpPr>
        <p:spPr bwMode="auto">
          <a:xfrm>
            <a:off x="1031875" y="735013"/>
            <a:ext cx="1119188" cy="311150"/>
          </a:xfrm>
          <a:custGeom>
            <a:avLst/>
            <a:gdLst>
              <a:gd name="T0" fmla="*/ 4122 w 4122"/>
              <a:gd name="T1" fmla="*/ 858 h 858"/>
              <a:gd name="T2" fmla="*/ 0 w 4122"/>
              <a:gd name="T3" fmla="*/ 858 h 858"/>
              <a:gd name="T4" fmla="*/ 0 w 4122"/>
              <a:gd name="T5" fmla="*/ 0 h 85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22" h="858">
                <a:moveTo>
                  <a:pt x="4122" y="858"/>
                </a:moveTo>
                <a:lnTo>
                  <a:pt x="0" y="858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4" name="Freeform 72"/>
          <p:cNvSpPr>
            <a:spLocks/>
          </p:cNvSpPr>
          <p:nvPr/>
        </p:nvSpPr>
        <p:spPr bwMode="auto">
          <a:xfrm>
            <a:off x="6708775" y="4652963"/>
            <a:ext cx="87313" cy="534988"/>
          </a:xfrm>
          <a:custGeom>
            <a:avLst/>
            <a:gdLst>
              <a:gd name="T0" fmla="*/ 320 w 320"/>
              <a:gd name="T1" fmla="*/ 1478 h 1478"/>
              <a:gd name="T2" fmla="*/ 0 w 320"/>
              <a:gd name="T3" fmla="*/ 1478 h 1478"/>
              <a:gd name="T4" fmla="*/ 0 w 320"/>
              <a:gd name="T5" fmla="*/ 0 h 14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0" h="1478">
                <a:moveTo>
                  <a:pt x="320" y="1478"/>
                </a:moveTo>
                <a:lnTo>
                  <a:pt x="0" y="1478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5" name="Freeform 73"/>
          <p:cNvSpPr>
            <a:spLocks/>
          </p:cNvSpPr>
          <p:nvPr/>
        </p:nvSpPr>
        <p:spPr bwMode="auto">
          <a:xfrm>
            <a:off x="3417888" y="5946775"/>
            <a:ext cx="4406900" cy="138113"/>
          </a:xfrm>
          <a:custGeom>
            <a:avLst/>
            <a:gdLst>
              <a:gd name="T0" fmla="*/ 16246 w 16246"/>
              <a:gd name="T1" fmla="*/ 382 h 382"/>
              <a:gd name="T2" fmla="*/ 0 w 16246"/>
              <a:gd name="T3" fmla="*/ 382 h 382"/>
              <a:gd name="T4" fmla="*/ 0 w 16246"/>
              <a:gd name="T5" fmla="*/ 0 h 3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46" h="382">
                <a:moveTo>
                  <a:pt x="16246" y="382"/>
                </a:moveTo>
                <a:lnTo>
                  <a:pt x="0" y="382"/>
                </a:lnTo>
                <a:lnTo>
                  <a:pt x="0" y="0"/>
                </a:lnTo>
              </a:path>
            </a:pathLst>
          </a:custGeom>
          <a:noFill/>
          <a:ln w="15875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6" name="Rectangle 74"/>
          <p:cNvSpPr>
            <a:spLocks noChangeArrowheads="1"/>
          </p:cNvSpPr>
          <p:nvPr/>
        </p:nvSpPr>
        <p:spPr bwMode="auto">
          <a:xfrm>
            <a:off x="4986338" y="1360488"/>
            <a:ext cx="85279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0A088AHI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7" name="Rectangle 75"/>
          <p:cNvSpPr>
            <a:spLocks noChangeArrowheads="1"/>
          </p:cNvSpPr>
          <p:nvPr/>
        </p:nvSpPr>
        <p:spPr bwMode="auto">
          <a:xfrm>
            <a:off x="6865938" y="3844925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00215g0772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8" name="Rectangle 76"/>
          <p:cNvSpPr>
            <a:spLocks noChangeArrowheads="1"/>
          </p:cNvSpPr>
          <p:nvPr/>
        </p:nvSpPr>
        <p:spPr bwMode="auto">
          <a:xfrm>
            <a:off x="6834188" y="5226050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5328g05323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79" name="Rectangle 77"/>
          <p:cNvSpPr>
            <a:spLocks noChangeArrowheads="1"/>
          </p:cNvSpPr>
          <p:nvPr/>
        </p:nvSpPr>
        <p:spPr bwMode="auto">
          <a:xfrm>
            <a:off x="6691313" y="3017838"/>
            <a:ext cx="95378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10558g4416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0" name="Rectangle 78"/>
          <p:cNvSpPr>
            <a:spLocks noChangeArrowheads="1"/>
          </p:cNvSpPr>
          <p:nvPr/>
        </p:nvSpPr>
        <p:spPr bwMode="auto">
          <a:xfrm>
            <a:off x="6888163" y="4673600"/>
            <a:ext cx="1250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371g00868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6845300" y="5502275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3716g03077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7296150" y="6330950"/>
            <a:ext cx="54341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Sp_Q098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>
            <a:off x="6723063" y="5778500"/>
            <a:ext cx="61715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Lm_E4ZLH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4" name="Rectangle 82"/>
          <p:cNvSpPr>
            <a:spLocks noChangeArrowheads="1"/>
          </p:cNvSpPr>
          <p:nvPr/>
        </p:nvSpPr>
        <p:spPr bwMode="auto">
          <a:xfrm>
            <a:off x="6508750" y="2465388"/>
            <a:ext cx="11044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Gp_GPLIN_0002653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5" name="Rectangle 83"/>
          <p:cNvSpPr>
            <a:spLocks noChangeArrowheads="1"/>
          </p:cNvSpPr>
          <p:nvPr/>
        </p:nvSpPr>
        <p:spPr bwMode="auto">
          <a:xfrm>
            <a:off x="6711950" y="3295650"/>
            <a:ext cx="101470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0268g006739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6" name="Rectangle 84"/>
          <p:cNvSpPr>
            <a:spLocks noChangeArrowheads="1"/>
          </p:cNvSpPr>
          <p:nvPr/>
        </p:nvSpPr>
        <p:spPr bwMode="auto">
          <a:xfrm>
            <a:off x="5087938" y="1084263"/>
            <a:ext cx="553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J9L3L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7" name="Rectangle 85"/>
          <p:cNvSpPr>
            <a:spLocks noChangeArrowheads="1"/>
          </p:cNvSpPr>
          <p:nvPr/>
        </p:nvSpPr>
        <p:spPr bwMode="auto">
          <a:xfrm>
            <a:off x="6888163" y="4397375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1215g01384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8" name="Rectangle 86"/>
          <p:cNvSpPr>
            <a:spLocks noChangeArrowheads="1"/>
          </p:cNvSpPr>
          <p:nvPr/>
        </p:nvSpPr>
        <p:spPr bwMode="auto">
          <a:xfrm>
            <a:off x="6175375" y="2741613"/>
            <a:ext cx="116538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h_Mhap1s0057g0417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89" name="Rectangle 87"/>
          <p:cNvSpPr>
            <a:spLocks noChangeArrowheads="1"/>
          </p:cNvSpPr>
          <p:nvPr/>
        </p:nvSpPr>
        <p:spPr bwMode="auto">
          <a:xfrm>
            <a:off x="7543800" y="808038"/>
            <a:ext cx="63959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Q9VER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0" name="Rectangle 88"/>
          <p:cNvSpPr>
            <a:spLocks noChangeArrowheads="1"/>
          </p:cNvSpPr>
          <p:nvPr/>
        </p:nvSpPr>
        <p:spPr bwMode="auto">
          <a:xfrm>
            <a:off x="6572250" y="3568700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i_Minc3s02114g2836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1" name="Rectangle 89"/>
          <p:cNvSpPr>
            <a:spLocks noChangeArrowheads="1"/>
          </p:cNvSpPr>
          <p:nvPr/>
        </p:nvSpPr>
        <p:spPr bwMode="auto">
          <a:xfrm>
            <a:off x="6823075" y="4949825"/>
            <a:ext cx="12118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j_Mjav1s02142g02095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2" name="Rectangle 90"/>
          <p:cNvSpPr>
            <a:spLocks noChangeArrowheads="1"/>
          </p:cNvSpPr>
          <p:nvPr/>
        </p:nvSpPr>
        <p:spPr bwMode="auto">
          <a:xfrm>
            <a:off x="6948488" y="255588"/>
            <a:ext cx="5722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t_Q8LFA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3" name="Rectangle 91"/>
          <p:cNvSpPr>
            <a:spLocks noChangeArrowheads="1"/>
          </p:cNvSpPr>
          <p:nvPr/>
        </p:nvSpPr>
        <p:spPr bwMode="auto">
          <a:xfrm>
            <a:off x="6500813" y="2189163"/>
            <a:ext cx="55303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Ts_E5SR8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4" name="Rectangle 92"/>
          <p:cNvSpPr>
            <a:spLocks noChangeArrowheads="1"/>
          </p:cNvSpPr>
          <p:nvPr/>
        </p:nvSpPr>
        <p:spPr bwMode="auto">
          <a:xfrm>
            <a:off x="5719763" y="1636713"/>
            <a:ext cx="5722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Q09956</a:t>
            </a:r>
            <a:endParaRPr kumimoji="0" lang="fr-FR" altLang="fr-FR" sz="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5" name="Rectangle 93"/>
          <p:cNvSpPr>
            <a:spLocks noChangeArrowheads="1"/>
          </p:cNvSpPr>
          <p:nvPr/>
        </p:nvSpPr>
        <p:spPr bwMode="auto">
          <a:xfrm>
            <a:off x="5456238" y="531813"/>
            <a:ext cx="57868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Q8N3J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6" name="Rectangle 94"/>
          <p:cNvSpPr>
            <a:spLocks noChangeArrowheads="1"/>
          </p:cNvSpPr>
          <p:nvPr/>
        </p:nvSpPr>
        <p:spPr bwMode="auto">
          <a:xfrm>
            <a:off x="6888163" y="4121150"/>
            <a:ext cx="101470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Ma_Mare1s06159g057503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7" name="Rectangle 95"/>
          <p:cNvSpPr>
            <a:spLocks noChangeArrowheads="1"/>
          </p:cNvSpPr>
          <p:nvPr/>
        </p:nvSpPr>
        <p:spPr bwMode="auto">
          <a:xfrm>
            <a:off x="7853363" y="6054725"/>
            <a:ext cx="5594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Bc_G2XS1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8" name="Rectangle 96"/>
          <p:cNvSpPr>
            <a:spLocks noChangeArrowheads="1"/>
          </p:cNvSpPr>
          <p:nvPr/>
        </p:nvSpPr>
        <p:spPr bwMode="auto">
          <a:xfrm>
            <a:off x="5757863" y="1912938"/>
            <a:ext cx="59952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s_U1M5A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9" name="Rectangle 97"/>
          <p:cNvSpPr>
            <a:spLocks noChangeArrowheads="1"/>
          </p:cNvSpPr>
          <p:nvPr/>
        </p:nvSpPr>
        <p:spPr bwMode="auto">
          <a:xfrm>
            <a:off x="6583363" y="453548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84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0" name="Rectangle 98"/>
          <p:cNvSpPr>
            <a:spLocks noChangeArrowheads="1"/>
          </p:cNvSpPr>
          <p:nvPr/>
        </p:nvSpPr>
        <p:spPr bwMode="auto">
          <a:xfrm>
            <a:off x="6319838" y="34448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7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1" name="Rectangle 99"/>
          <p:cNvSpPr>
            <a:spLocks noChangeArrowheads="1"/>
          </p:cNvSpPr>
          <p:nvPr/>
        </p:nvSpPr>
        <p:spPr bwMode="auto">
          <a:xfrm>
            <a:off x="6454775" y="34591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6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2" name="Rectangle 100"/>
          <p:cNvSpPr>
            <a:spLocks noChangeArrowheads="1"/>
          </p:cNvSpPr>
          <p:nvPr/>
        </p:nvSpPr>
        <p:spPr bwMode="auto">
          <a:xfrm>
            <a:off x="2698750" y="114300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71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3" name="Rectangle 101"/>
          <p:cNvSpPr>
            <a:spLocks noChangeArrowheads="1"/>
          </p:cNvSpPr>
          <p:nvPr/>
        </p:nvSpPr>
        <p:spPr bwMode="auto">
          <a:xfrm>
            <a:off x="6445250" y="40671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7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4" name="Rectangle 102"/>
          <p:cNvSpPr>
            <a:spLocks noChangeArrowheads="1"/>
          </p:cNvSpPr>
          <p:nvPr/>
        </p:nvSpPr>
        <p:spPr bwMode="auto">
          <a:xfrm>
            <a:off x="6757988" y="43672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97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5" name="Rectangle 103"/>
          <p:cNvSpPr>
            <a:spLocks noChangeArrowheads="1"/>
          </p:cNvSpPr>
          <p:nvPr/>
        </p:nvSpPr>
        <p:spPr bwMode="auto">
          <a:xfrm>
            <a:off x="303213" y="121443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75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6" name="Rectangle 104"/>
          <p:cNvSpPr>
            <a:spLocks noChangeArrowheads="1"/>
          </p:cNvSpPr>
          <p:nvPr/>
        </p:nvSpPr>
        <p:spPr bwMode="auto">
          <a:xfrm>
            <a:off x="6707188" y="53959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6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7" name="Rectangle 105"/>
          <p:cNvSpPr>
            <a:spLocks noChangeArrowheads="1"/>
          </p:cNvSpPr>
          <p:nvPr/>
        </p:nvSpPr>
        <p:spPr bwMode="auto">
          <a:xfrm>
            <a:off x="1362075" y="29845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55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8" name="Rectangle 106"/>
          <p:cNvSpPr>
            <a:spLocks noChangeArrowheads="1"/>
          </p:cNvSpPr>
          <p:nvPr/>
        </p:nvSpPr>
        <p:spPr bwMode="auto">
          <a:xfrm>
            <a:off x="1574800" y="602138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7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9" name="Rectangle 107"/>
          <p:cNvSpPr>
            <a:spLocks noChangeArrowheads="1"/>
          </p:cNvSpPr>
          <p:nvPr/>
        </p:nvSpPr>
        <p:spPr bwMode="auto">
          <a:xfrm>
            <a:off x="3286125" y="58404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96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0" name="Rectangle 108"/>
          <p:cNvSpPr>
            <a:spLocks noChangeArrowheads="1"/>
          </p:cNvSpPr>
          <p:nvPr/>
        </p:nvSpPr>
        <p:spPr bwMode="auto">
          <a:xfrm>
            <a:off x="6770688" y="45323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99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1" name="Rectangle 109"/>
          <p:cNvSpPr>
            <a:spLocks noChangeArrowheads="1"/>
          </p:cNvSpPr>
          <p:nvPr/>
        </p:nvSpPr>
        <p:spPr bwMode="auto">
          <a:xfrm>
            <a:off x="6675438" y="39909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83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2" name="Rectangle 110"/>
          <p:cNvSpPr>
            <a:spLocks noChangeArrowheads="1"/>
          </p:cNvSpPr>
          <p:nvPr/>
        </p:nvSpPr>
        <p:spPr bwMode="auto">
          <a:xfrm>
            <a:off x="2290763" y="23987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4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3" name="Rectangle 111"/>
          <p:cNvSpPr>
            <a:spLocks noChangeArrowheads="1"/>
          </p:cNvSpPr>
          <p:nvPr/>
        </p:nvSpPr>
        <p:spPr bwMode="auto">
          <a:xfrm>
            <a:off x="3328988" y="27098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85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4" name="Rectangle 112"/>
          <p:cNvSpPr>
            <a:spLocks noChangeArrowheads="1"/>
          </p:cNvSpPr>
          <p:nvPr/>
        </p:nvSpPr>
        <p:spPr bwMode="auto">
          <a:xfrm>
            <a:off x="5772150" y="30273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5" name="Rectangle 113"/>
          <p:cNvSpPr>
            <a:spLocks noChangeArrowheads="1"/>
          </p:cNvSpPr>
          <p:nvPr/>
        </p:nvSpPr>
        <p:spPr bwMode="auto">
          <a:xfrm>
            <a:off x="898525" y="18335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45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6" name="Rectangle 114"/>
          <p:cNvSpPr>
            <a:spLocks noChangeArrowheads="1"/>
          </p:cNvSpPr>
          <p:nvPr/>
        </p:nvSpPr>
        <p:spPr bwMode="auto">
          <a:xfrm>
            <a:off x="2028825" y="9318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8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7" name="Rectangle 115"/>
          <p:cNvSpPr>
            <a:spLocks noChangeArrowheads="1"/>
          </p:cNvSpPr>
          <p:nvPr/>
        </p:nvSpPr>
        <p:spPr bwMode="auto">
          <a:xfrm>
            <a:off x="6683375" y="519430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88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8" name="Rectangle 116"/>
          <p:cNvSpPr>
            <a:spLocks noChangeArrowheads="1"/>
          </p:cNvSpPr>
          <p:nvPr/>
        </p:nvSpPr>
        <p:spPr bwMode="auto">
          <a:xfrm>
            <a:off x="1701800" y="212090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4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9" name="Rectangle 117"/>
          <p:cNvSpPr>
            <a:spLocks noChangeArrowheads="1"/>
          </p:cNvSpPr>
          <p:nvPr/>
        </p:nvSpPr>
        <p:spPr bwMode="auto">
          <a:xfrm>
            <a:off x="915988" y="61595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52</a:t>
            </a:r>
            <a:endParaRPr kumimoji="0" lang="fr-FR" altLang="fr-F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0" name="ZoneTexte 119"/>
          <p:cNvSpPr txBox="1"/>
          <p:nvPr/>
        </p:nvSpPr>
        <p:spPr>
          <a:xfrm>
            <a:off x="7513334" y="1039019"/>
            <a:ext cx="1490966" cy="70788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800" b="1" dirty="0" smtClean="0"/>
              <a:t>6mA </a:t>
            </a:r>
            <a:r>
              <a:rPr lang="fr-FR" sz="800" b="1" dirty="0" err="1" smtClean="0"/>
              <a:t>methyltransferase</a:t>
            </a:r>
            <a:endParaRPr lang="fr-FR" sz="800" b="1" dirty="0" smtClean="0"/>
          </a:p>
          <a:p>
            <a:r>
              <a:rPr lang="fr-FR" sz="800" dirty="0" err="1" smtClean="0"/>
              <a:t>RaxML</a:t>
            </a:r>
            <a:r>
              <a:rPr lang="fr-FR" sz="800" dirty="0" smtClean="0"/>
              <a:t> </a:t>
            </a:r>
            <a:endParaRPr lang="fr-FR" sz="800" dirty="0" smtClean="0"/>
          </a:p>
          <a:p>
            <a:r>
              <a:rPr lang="fr-FR" sz="800" dirty="0" smtClean="0"/>
              <a:t>PROTGAMMAAUTO</a:t>
            </a:r>
          </a:p>
          <a:p>
            <a:r>
              <a:rPr lang="fr-FR" sz="800" dirty="0" smtClean="0"/>
              <a:t>1000 </a:t>
            </a:r>
            <a:r>
              <a:rPr lang="fr-FR" sz="800" dirty="0" err="1" smtClean="0"/>
              <a:t>bootstrap</a:t>
            </a:r>
            <a:endParaRPr lang="fr-FR" sz="800" dirty="0" smtClean="0"/>
          </a:p>
          <a:p>
            <a:r>
              <a:rPr lang="fr-FR" sz="800" dirty="0" smtClean="0"/>
              <a:t>Best model : LG</a:t>
            </a:r>
            <a:endParaRPr lang="fr-FR" sz="800" dirty="0"/>
          </a:p>
        </p:txBody>
      </p:sp>
      <p:sp>
        <p:nvSpPr>
          <p:cNvPr id="121" name="Rectangle 92"/>
          <p:cNvSpPr>
            <a:spLocks noChangeArrowheads="1"/>
          </p:cNvSpPr>
          <p:nvPr/>
        </p:nvSpPr>
        <p:spPr bwMode="auto">
          <a:xfrm>
            <a:off x="6339400" y="1642836"/>
            <a:ext cx="431208" cy="1489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1" i="0" u="none" strike="noStrike" cap="none" normalizeH="0" baseline="0" dirty="0" smtClean="0">
                <a:ln>
                  <a:noFill/>
                </a:ln>
                <a:solidFill>
                  <a:srgbClr val="FF0000"/>
                </a:solidFill>
                <a:effectLst/>
                <a:latin typeface="Adobe Devanagari" panose="02040503050201020203" pitchFamily="18" charset="0"/>
              </a:rPr>
              <a:t>DAMT-1</a:t>
            </a:r>
            <a:endParaRPr kumimoji="0" lang="fr-FR" altLang="fr-FR" sz="800" b="1" i="0" u="none" strike="noStrike" cap="none" normalizeH="0" baseline="0" dirty="0" smtClean="0">
              <a:ln>
                <a:noFill/>
              </a:ln>
              <a:solidFill>
                <a:srgbClr val="FF0000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38393232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1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Thème1" id="{8369EA16-FC18-420F-B65D-1B55019E0363}" vid="{80D3CE8A-49F4-4B44-AEE0-29301DB73F4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8</TotalTime>
  <Words>56</Words>
  <Application>Microsoft Office PowerPoint</Application>
  <PresentationFormat>Affichage à l'écra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1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tienne Danchin</dc:creator>
  <cp:lastModifiedBy>zurletto</cp:lastModifiedBy>
  <cp:revision>3</cp:revision>
  <dcterms:created xsi:type="dcterms:W3CDTF">2018-02-13T10:39:33Z</dcterms:created>
  <dcterms:modified xsi:type="dcterms:W3CDTF">2018-02-28T08:22:06Z</dcterms:modified>
</cp:coreProperties>
</file>